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theme/themeOverride1.xml" ContentType="application/vnd.openxmlformats-officedocument.themeOverr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166" autoAdjust="0"/>
    <p:restoredTop sz="94660"/>
  </p:normalViewPr>
  <p:slideViewPr>
    <p:cSldViewPr snapToGrid="0">
      <p:cViewPr varScale="1">
        <p:scale>
          <a:sx n="68" d="100"/>
          <a:sy n="68" d="100"/>
        </p:scale>
        <p:origin x="166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KAGAWA Tomohiro" userId="d74b3e309c52a267" providerId="LiveId" clId="{75BADE36-D135-44E3-A78F-3516F48BF828}"/>
    <pc:docChg chg="undo custSel modSld">
      <pc:chgData name="OKAGAWA Tomohiro" userId="d74b3e309c52a267" providerId="LiveId" clId="{75BADE36-D135-44E3-A78F-3516F48BF828}" dt="2021-12-28T01:53:35.412" v="96" actId="14100"/>
      <pc:docMkLst>
        <pc:docMk/>
      </pc:docMkLst>
      <pc:sldChg chg="addSp modSp mod">
        <pc:chgData name="OKAGAWA Tomohiro" userId="d74b3e309c52a267" providerId="LiveId" clId="{75BADE36-D135-44E3-A78F-3516F48BF828}" dt="2021-12-28T01:53:35.412" v="96" actId="14100"/>
        <pc:sldMkLst>
          <pc:docMk/>
          <pc:sldMk cId="4282525776" sldId="256"/>
        </pc:sldMkLst>
        <pc:spChg chg="mod">
          <ac:chgData name="OKAGAWA Tomohiro" userId="d74b3e309c52a267" providerId="LiveId" clId="{75BADE36-D135-44E3-A78F-3516F48BF828}" dt="2021-12-28T01:52:45.602" v="67" actId="1035"/>
          <ac:spMkLst>
            <pc:docMk/>
            <pc:sldMk cId="4282525776" sldId="256"/>
            <ac:spMk id="138" creationId="{DFDF95D8-B357-43DF-9B17-8601D803838E}"/>
          </ac:spMkLst>
        </pc:spChg>
        <pc:spChg chg="mod">
          <ac:chgData name="OKAGAWA Tomohiro" userId="d74b3e309c52a267" providerId="LiveId" clId="{75BADE36-D135-44E3-A78F-3516F48BF828}" dt="2021-12-28T01:52:45.602" v="67" actId="1035"/>
          <ac:spMkLst>
            <pc:docMk/>
            <pc:sldMk cId="4282525776" sldId="256"/>
            <ac:spMk id="139" creationId="{CD601760-96FA-4B3A-8C3A-744723CEDE29}"/>
          </ac:spMkLst>
        </pc:spChg>
        <pc:spChg chg="mod">
          <ac:chgData name="OKAGAWA Tomohiro" userId="d74b3e309c52a267" providerId="LiveId" clId="{75BADE36-D135-44E3-A78F-3516F48BF828}" dt="2021-12-28T01:52:45.602" v="67" actId="1035"/>
          <ac:spMkLst>
            <pc:docMk/>
            <pc:sldMk cId="4282525776" sldId="256"/>
            <ac:spMk id="140" creationId="{59D467CB-33B1-4CA3-8E6D-3183ED61E224}"/>
          </ac:spMkLst>
        </pc:spChg>
        <pc:spChg chg="mod">
          <ac:chgData name="OKAGAWA Tomohiro" userId="d74b3e309c52a267" providerId="LiveId" clId="{75BADE36-D135-44E3-A78F-3516F48BF828}" dt="2021-12-28T01:52:45.602" v="67" actId="1035"/>
          <ac:spMkLst>
            <pc:docMk/>
            <pc:sldMk cId="4282525776" sldId="256"/>
            <ac:spMk id="141" creationId="{1AFC04EB-1A16-4F14-A864-35E7E44F8273}"/>
          </ac:spMkLst>
        </pc:spChg>
        <pc:spChg chg="mod">
          <ac:chgData name="OKAGAWA Tomohiro" userId="d74b3e309c52a267" providerId="LiveId" clId="{75BADE36-D135-44E3-A78F-3516F48BF828}" dt="2021-12-28T01:52:45.602" v="67" actId="1035"/>
          <ac:spMkLst>
            <pc:docMk/>
            <pc:sldMk cId="4282525776" sldId="256"/>
            <ac:spMk id="142" creationId="{5F15F3C2-BFC9-4ECD-A783-3B956FD0F51C}"/>
          </ac:spMkLst>
        </pc:spChg>
        <pc:spChg chg="mod">
          <ac:chgData name="OKAGAWA Tomohiro" userId="d74b3e309c52a267" providerId="LiveId" clId="{75BADE36-D135-44E3-A78F-3516F48BF828}" dt="2021-12-28T01:52:29.821" v="61" actId="164"/>
          <ac:spMkLst>
            <pc:docMk/>
            <pc:sldMk cId="4282525776" sldId="256"/>
            <ac:spMk id="204" creationId="{0802CD19-DB20-49F2-A6BB-6A8C3D0ABCD6}"/>
          </ac:spMkLst>
        </pc:spChg>
        <pc:spChg chg="mod">
          <ac:chgData name="OKAGAWA Tomohiro" userId="d74b3e309c52a267" providerId="LiveId" clId="{75BADE36-D135-44E3-A78F-3516F48BF828}" dt="2021-12-28T01:52:29.821" v="61" actId="164"/>
          <ac:spMkLst>
            <pc:docMk/>
            <pc:sldMk cId="4282525776" sldId="256"/>
            <ac:spMk id="205" creationId="{17160D7E-FD91-4AD5-8210-857F5E7A9BD5}"/>
          </ac:spMkLst>
        </pc:spChg>
        <pc:spChg chg="mod">
          <ac:chgData name="OKAGAWA Tomohiro" userId="d74b3e309c52a267" providerId="LiveId" clId="{75BADE36-D135-44E3-A78F-3516F48BF828}" dt="2021-12-28T01:52:29.821" v="61" actId="164"/>
          <ac:spMkLst>
            <pc:docMk/>
            <pc:sldMk cId="4282525776" sldId="256"/>
            <ac:spMk id="206" creationId="{2282024B-C8B5-4EB0-AD3F-F981B7E23CB3}"/>
          </ac:spMkLst>
        </pc:spChg>
        <pc:spChg chg="mod">
          <ac:chgData name="OKAGAWA Tomohiro" userId="d74b3e309c52a267" providerId="LiveId" clId="{75BADE36-D135-44E3-A78F-3516F48BF828}" dt="2021-12-28T01:52:29.821" v="61" actId="164"/>
          <ac:spMkLst>
            <pc:docMk/>
            <pc:sldMk cId="4282525776" sldId="256"/>
            <ac:spMk id="207" creationId="{0A527773-E1A2-4E82-BAFC-43C6DFAC76E0}"/>
          </ac:spMkLst>
        </pc:spChg>
        <pc:spChg chg="mod">
          <ac:chgData name="OKAGAWA Tomohiro" userId="d74b3e309c52a267" providerId="LiveId" clId="{75BADE36-D135-44E3-A78F-3516F48BF828}" dt="2021-12-28T01:52:29.821" v="61" actId="164"/>
          <ac:spMkLst>
            <pc:docMk/>
            <pc:sldMk cId="4282525776" sldId="256"/>
            <ac:spMk id="208" creationId="{A0B6099F-3D33-4E27-A28A-6CC8393BC4D9}"/>
          </ac:spMkLst>
        </pc:spChg>
        <pc:spChg chg="mod">
          <ac:chgData name="OKAGAWA Tomohiro" userId="d74b3e309c52a267" providerId="LiveId" clId="{75BADE36-D135-44E3-A78F-3516F48BF828}" dt="2021-12-28T01:52:33.848" v="64" actId="164"/>
          <ac:spMkLst>
            <pc:docMk/>
            <pc:sldMk cId="4282525776" sldId="256"/>
            <ac:spMk id="251" creationId="{327858A6-8BD7-4702-AA64-66C7353FDB49}"/>
          </ac:spMkLst>
        </pc:spChg>
        <pc:spChg chg="mod">
          <ac:chgData name="OKAGAWA Tomohiro" userId="d74b3e309c52a267" providerId="LiveId" clId="{75BADE36-D135-44E3-A78F-3516F48BF828}" dt="2021-12-28T01:52:33.848" v="64" actId="164"/>
          <ac:spMkLst>
            <pc:docMk/>
            <pc:sldMk cId="4282525776" sldId="256"/>
            <ac:spMk id="252" creationId="{E8FBFB14-E75E-456B-9C75-31B9CC63A5DA}"/>
          </ac:spMkLst>
        </pc:spChg>
        <pc:spChg chg="mod">
          <ac:chgData name="OKAGAWA Tomohiro" userId="d74b3e309c52a267" providerId="LiveId" clId="{75BADE36-D135-44E3-A78F-3516F48BF828}" dt="2021-12-28T01:52:33.848" v="64" actId="164"/>
          <ac:spMkLst>
            <pc:docMk/>
            <pc:sldMk cId="4282525776" sldId="256"/>
            <ac:spMk id="253" creationId="{72C8FA85-0255-487E-B937-100177028455}"/>
          </ac:spMkLst>
        </pc:spChg>
        <pc:spChg chg="mod">
          <ac:chgData name="OKAGAWA Tomohiro" userId="d74b3e309c52a267" providerId="LiveId" clId="{75BADE36-D135-44E3-A78F-3516F48BF828}" dt="2021-12-28T01:52:33.848" v="64" actId="164"/>
          <ac:spMkLst>
            <pc:docMk/>
            <pc:sldMk cId="4282525776" sldId="256"/>
            <ac:spMk id="254" creationId="{5B779BCD-4354-4A05-BD9D-BDB6B012E7E3}"/>
          </ac:spMkLst>
        </pc:spChg>
        <pc:spChg chg="mod">
          <ac:chgData name="OKAGAWA Tomohiro" userId="d74b3e309c52a267" providerId="LiveId" clId="{75BADE36-D135-44E3-A78F-3516F48BF828}" dt="2021-12-28T01:52:33.848" v="64" actId="164"/>
          <ac:spMkLst>
            <pc:docMk/>
            <pc:sldMk cId="4282525776" sldId="256"/>
            <ac:spMk id="255" creationId="{15D5D17E-E35D-4A87-852A-87B5DE35D7ED}"/>
          </ac:spMkLst>
        </pc:spChg>
        <pc:spChg chg="mod">
          <ac:chgData name="OKAGAWA Tomohiro" userId="d74b3e309c52a267" providerId="LiveId" clId="{75BADE36-D135-44E3-A78F-3516F48BF828}" dt="2021-12-28T01:53:35.412" v="96" actId="14100"/>
          <ac:spMkLst>
            <pc:docMk/>
            <pc:sldMk cId="4282525776" sldId="256"/>
            <ac:spMk id="308" creationId="{8A6F30CD-D532-4CA6-9841-22602DF89725}"/>
          </ac:spMkLst>
        </pc:spChg>
        <pc:spChg chg="mod">
          <ac:chgData name="OKAGAWA Tomohiro" userId="d74b3e309c52a267" providerId="LiveId" clId="{75BADE36-D135-44E3-A78F-3516F48BF828}" dt="2021-12-28T01:53:35.412" v="96" actId="14100"/>
          <ac:spMkLst>
            <pc:docMk/>
            <pc:sldMk cId="4282525776" sldId="256"/>
            <ac:spMk id="309" creationId="{7C92B87B-CC46-4D21-BB8F-D53E6DDB4792}"/>
          </ac:spMkLst>
        </pc:spChg>
        <pc:spChg chg="mod">
          <ac:chgData name="OKAGAWA Tomohiro" userId="d74b3e309c52a267" providerId="LiveId" clId="{75BADE36-D135-44E3-A78F-3516F48BF828}" dt="2021-12-28T01:53:35.412" v="96" actId="14100"/>
          <ac:spMkLst>
            <pc:docMk/>
            <pc:sldMk cId="4282525776" sldId="256"/>
            <ac:spMk id="310" creationId="{80EB3888-B9C9-4315-B4A0-56B89F6B3D24}"/>
          </ac:spMkLst>
        </pc:spChg>
        <pc:spChg chg="mod">
          <ac:chgData name="OKAGAWA Tomohiro" userId="d74b3e309c52a267" providerId="LiveId" clId="{75BADE36-D135-44E3-A78F-3516F48BF828}" dt="2021-12-28T01:53:35.412" v="96" actId="14100"/>
          <ac:spMkLst>
            <pc:docMk/>
            <pc:sldMk cId="4282525776" sldId="256"/>
            <ac:spMk id="311" creationId="{CC823E47-B3A3-4341-A6DB-3BAC2163F0C8}"/>
          </ac:spMkLst>
        </pc:s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4" creationId="{9BE6D51C-D593-4FF4-8141-2F4998AC97DA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5" creationId="{BC69CD75-CBAE-4804-BDF4-348C5967991B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6" creationId="{DE80BE6E-0CC8-4C43-99BE-B86CF2E32327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7" creationId="{9A958313-3D83-40CD-9200-C980C5416034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9" creationId="{9D2128F1-42F6-44D8-B0FB-56D5DEC35194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10" creationId="{D10B65A6-B7F2-4CC8-9B23-8DD22B70097A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11" creationId="{F6AB37EA-CAC2-46B2-955B-0AA8697E5BAE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12" creationId="{36541772-1164-4173-ABF4-A504A338E005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13" creationId="{C65EA468-A233-40C9-8795-C55863616DA0}"/>
          </ac:grpSpMkLst>
        </pc:grpChg>
        <pc:grpChg chg="mod">
          <ac:chgData name="OKAGAWA Tomohiro" userId="d74b3e309c52a267" providerId="LiveId" clId="{75BADE36-D135-44E3-A78F-3516F48BF828}" dt="2021-12-28T01:52:25.341" v="60" actId="1076"/>
          <ac:grpSpMkLst>
            <pc:docMk/>
            <pc:sldMk cId="4282525776" sldId="256"/>
            <ac:grpSpMk id="14" creationId="{1F3D668B-7FE1-4C08-8B21-C56885343819}"/>
          </ac:grpSpMkLst>
        </pc:grpChg>
        <pc:grpChg chg="add mod">
          <ac:chgData name="OKAGAWA Tomohiro" userId="d74b3e309c52a267" providerId="LiveId" clId="{75BADE36-D135-44E3-A78F-3516F48BF828}" dt="2021-12-28T01:52:29.821" v="61" actId="164"/>
          <ac:grpSpMkLst>
            <pc:docMk/>
            <pc:sldMk cId="4282525776" sldId="256"/>
            <ac:grpSpMk id="16" creationId="{B993CF61-7C51-4103-B6EC-1B08611A8C58}"/>
          </ac:grpSpMkLst>
        </pc:grpChg>
        <pc:grpChg chg="add mod">
          <ac:chgData name="OKAGAWA Tomohiro" userId="d74b3e309c52a267" providerId="LiveId" clId="{75BADE36-D135-44E3-A78F-3516F48BF828}" dt="2021-12-28T01:52:32.920" v="63" actId="164"/>
          <ac:grpSpMkLst>
            <pc:docMk/>
            <pc:sldMk cId="4282525776" sldId="256"/>
            <ac:grpSpMk id="17" creationId="{89622BE6-29C2-4EAE-8B93-66CB0234CA32}"/>
          </ac:grpSpMkLst>
        </pc:grpChg>
        <pc:grpChg chg="add mod">
          <ac:chgData name="OKAGAWA Tomohiro" userId="d74b3e309c52a267" providerId="LiveId" clId="{75BADE36-D135-44E3-A78F-3516F48BF828}" dt="2021-12-28T01:52:33.848" v="64" actId="164"/>
          <ac:grpSpMkLst>
            <pc:docMk/>
            <pc:sldMk cId="4282525776" sldId="256"/>
            <ac:grpSpMk id="18" creationId="{0E2D5BCA-DA66-4B1C-B91E-6C1E250891FF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157" creationId="{E1B9FD43-D08C-431D-B1DD-B3DE34C4537C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171" creationId="{D301B339-8E17-45F2-A858-119DB467AB8A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178" creationId="{17690C5A-1723-49C8-9F6D-5B106591572F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238" creationId="{244B0FFD-3C66-415C-ABFB-316E6B40E8D4}"/>
          </ac:grpSpMkLst>
        </pc:grpChg>
        <pc:grpChg chg="mod">
          <ac:chgData name="OKAGAWA Tomohiro" userId="d74b3e309c52a267" providerId="LiveId" clId="{75BADE36-D135-44E3-A78F-3516F48BF828}" dt="2021-12-28T01:52:20.262" v="58" actId="1035"/>
          <ac:grpSpMkLst>
            <pc:docMk/>
            <pc:sldMk cId="4282525776" sldId="256"/>
            <ac:grpSpMk id="268" creationId="{3D0D53C5-B584-405E-BA17-01CD6BE9D5F9}"/>
          </ac:grpSpMkLst>
        </pc:grpChg>
        <pc:graphicFrameChg chg="mod">
          <ac:chgData name="OKAGAWA Tomohiro" userId="d74b3e309c52a267" providerId="LiveId" clId="{75BADE36-D135-44E3-A78F-3516F48BF828}" dt="2021-12-28T01:52:20.262" v="58" actId="1035"/>
          <ac:graphicFrameMkLst>
            <pc:docMk/>
            <pc:sldMk cId="4282525776" sldId="256"/>
            <ac:graphicFrameMk id="156" creationId="{96020893-7042-40DD-B397-AF04A8A5C00F}"/>
          </ac:graphicFrameMkLst>
        </pc:graphicFrameChg>
        <pc:graphicFrameChg chg="mod">
          <ac:chgData name="OKAGAWA Tomohiro" userId="d74b3e309c52a267" providerId="LiveId" clId="{75BADE36-D135-44E3-A78F-3516F48BF828}" dt="2021-12-28T01:52:29.821" v="61" actId="164"/>
          <ac:graphicFrameMkLst>
            <pc:docMk/>
            <pc:sldMk cId="4282525776" sldId="256"/>
            <ac:graphicFrameMk id="203" creationId="{66B028DD-37F9-4778-81DC-F3028C748A39}"/>
          </ac:graphicFrameMkLst>
        </pc:graphicFrameChg>
        <pc:graphicFrameChg chg="mod">
          <ac:chgData name="OKAGAWA Tomohiro" userId="d74b3e309c52a267" providerId="LiveId" clId="{75BADE36-D135-44E3-A78F-3516F48BF828}" dt="2021-12-28T01:52:33.848" v="64" actId="164"/>
          <ac:graphicFrameMkLst>
            <pc:docMk/>
            <pc:sldMk cId="4282525776" sldId="256"/>
            <ac:graphicFrameMk id="250" creationId="{6EAD10FA-D65A-49A6-95B9-4321DC2B44BE}"/>
          </ac:graphicFrameMkLst>
        </pc:graphicFrameChg>
      </pc:sldChg>
      <pc:sldChg chg="modSp mod">
        <pc:chgData name="OKAGAWA Tomohiro" userId="d74b3e309c52a267" providerId="LiveId" clId="{75BADE36-D135-44E3-A78F-3516F48BF828}" dt="2021-12-28T01:53:29.050" v="95" actId="14100"/>
        <pc:sldMkLst>
          <pc:docMk/>
          <pc:sldMk cId="1049214770" sldId="258"/>
        </pc:sldMkLst>
        <pc:spChg chg="mod">
          <ac:chgData name="OKAGAWA Tomohiro" userId="d74b3e309c52a267" providerId="LiveId" clId="{75BADE36-D135-44E3-A78F-3516F48BF828}" dt="2021-12-28T01:52:52.002" v="68" actId="1036"/>
          <ac:spMkLst>
            <pc:docMk/>
            <pc:sldMk cId="1049214770" sldId="258"/>
            <ac:spMk id="14" creationId="{62B2D419-117B-4197-875F-48323B0501C5}"/>
          </ac:spMkLst>
        </pc:spChg>
        <pc:spChg chg="mod">
          <ac:chgData name="OKAGAWA Tomohiro" userId="d74b3e309c52a267" providerId="LiveId" clId="{75BADE36-D135-44E3-A78F-3516F48BF828}" dt="2021-12-28T01:52:52.002" v="68" actId="1036"/>
          <ac:spMkLst>
            <pc:docMk/>
            <pc:sldMk cId="1049214770" sldId="258"/>
            <ac:spMk id="22" creationId="{5E11D11A-0430-4FDE-ABEE-2327C1EF2331}"/>
          </ac:spMkLst>
        </pc:spChg>
        <pc:spChg chg="mod">
          <ac:chgData name="OKAGAWA Tomohiro" userId="d74b3e309c52a267" providerId="LiveId" clId="{75BADE36-D135-44E3-A78F-3516F48BF828}" dt="2021-12-28T01:52:52.002" v="68" actId="1036"/>
          <ac:spMkLst>
            <pc:docMk/>
            <pc:sldMk cId="1049214770" sldId="258"/>
            <ac:spMk id="23" creationId="{E0AF336E-F4C2-402B-8F6B-FB6919BF1C3E}"/>
          </ac:spMkLst>
        </pc:spChg>
        <pc:spChg chg="mod">
          <ac:chgData name="OKAGAWA Tomohiro" userId="d74b3e309c52a267" providerId="LiveId" clId="{75BADE36-D135-44E3-A78F-3516F48BF828}" dt="2021-12-28T01:52:52.002" v="68" actId="1036"/>
          <ac:spMkLst>
            <pc:docMk/>
            <pc:sldMk cId="1049214770" sldId="258"/>
            <ac:spMk id="24" creationId="{0C62D14F-DB67-4342-8167-8D35A5D4EBE3}"/>
          </ac:spMkLst>
        </pc:spChg>
        <pc:spChg chg="mod">
          <ac:chgData name="OKAGAWA Tomohiro" userId="d74b3e309c52a267" providerId="LiveId" clId="{75BADE36-D135-44E3-A78F-3516F48BF828}" dt="2021-12-28T01:52:52.002" v="68" actId="1036"/>
          <ac:spMkLst>
            <pc:docMk/>
            <pc:sldMk cId="1049214770" sldId="258"/>
            <ac:spMk id="25" creationId="{58405EC4-F9F3-4AEF-9058-A71A143BA2B7}"/>
          </ac:spMkLst>
        </pc:spChg>
        <pc:spChg chg="mod">
          <ac:chgData name="OKAGAWA Tomohiro" userId="d74b3e309c52a267" providerId="LiveId" clId="{75BADE36-D135-44E3-A78F-3516F48BF828}" dt="2021-12-28T01:53:29.050" v="95" actId="14100"/>
          <ac:spMkLst>
            <pc:docMk/>
            <pc:sldMk cId="1049214770" sldId="258"/>
            <ac:spMk id="48" creationId="{183674AD-C712-4537-AC33-0F276CBA7671}"/>
          </ac:spMkLst>
        </pc:spChg>
        <pc:spChg chg="mod">
          <ac:chgData name="OKAGAWA Tomohiro" userId="d74b3e309c52a267" providerId="LiveId" clId="{75BADE36-D135-44E3-A78F-3516F48BF828}" dt="2021-12-28T01:53:29.050" v="95" actId="14100"/>
          <ac:spMkLst>
            <pc:docMk/>
            <pc:sldMk cId="1049214770" sldId="258"/>
            <ac:spMk id="49" creationId="{7141F538-6366-428F-889F-852B285C5170}"/>
          </ac:spMkLst>
        </pc:spChg>
        <pc:spChg chg="mod">
          <ac:chgData name="OKAGAWA Tomohiro" userId="d74b3e309c52a267" providerId="LiveId" clId="{75BADE36-D135-44E3-A78F-3516F48BF828}" dt="2021-12-28T01:53:29.050" v="95" actId="14100"/>
          <ac:spMkLst>
            <pc:docMk/>
            <pc:sldMk cId="1049214770" sldId="258"/>
            <ac:spMk id="50" creationId="{4002E3E0-C19F-4E1A-B12B-9379560EC1AB}"/>
          </ac:spMkLst>
        </pc:spChg>
        <pc:spChg chg="mod">
          <ac:chgData name="OKAGAWA Tomohiro" userId="d74b3e309c52a267" providerId="LiveId" clId="{75BADE36-D135-44E3-A78F-3516F48BF828}" dt="2021-12-28T01:53:29.050" v="95" actId="14100"/>
          <ac:spMkLst>
            <pc:docMk/>
            <pc:sldMk cId="1049214770" sldId="258"/>
            <ac:spMk id="51" creationId="{20FE2F89-C457-463A-832F-F0816CC83C66}"/>
          </ac:spMkLst>
        </pc:spChg>
        <pc:graphicFrameChg chg="mod">
          <ac:chgData name="OKAGAWA Tomohiro" userId="d74b3e309c52a267" providerId="LiveId" clId="{75BADE36-D135-44E3-A78F-3516F48BF828}" dt="2021-12-28T01:52:00.405" v="54" actId="1035"/>
          <ac:graphicFrameMkLst>
            <pc:docMk/>
            <pc:sldMk cId="1049214770" sldId="258"/>
            <ac:graphicFrameMk id="28" creationId="{89D90997-1294-41F5-9F63-7E5FA8E45FB0}"/>
          </ac:graphicFrameMkLst>
        </pc:graphicFrameChg>
        <pc:graphicFrameChg chg="mod">
          <ac:chgData name="OKAGAWA Tomohiro" userId="d74b3e309c52a267" providerId="LiveId" clId="{75BADE36-D135-44E3-A78F-3516F48BF828}" dt="2021-12-28T01:52:00.405" v="54" actId="1035"/>
          <ac:graphicFrameMkLst>
            <pc:docMk/>
            <pc:sldMk cId="1049214770" sldId="258"/>
            <ac:graphicFrameMk id="29" creationId="{C3FDBCDA-F007-4832-876C-FC6C973E33D0}"/>
          </ac:graphicFrameMkLst>
        </pc:graphicFrameChg>
        <pc:graphicFrameChg chg="mod">
          <ac:chgData name="OKAGAWA Tomohiro" userId="d74b3e309c52a267" providerId="LiveId" clId="{75BADE36-D135-44E3-A78F-3516F48BF828}" dt="2021-12-28T01:51:27.036" v="38" actId="1035"/>
          <ac:graphicFrameMkLst>
            <pc:docMk/>
            <pc:sldMk cId="1049214770" sldId="258"/>
            <ac:graphicFrameMk id="30" creationId="{36364805-0C32-4061-8ED5-8440657D6BC8}"/>
          </ac:graphicFrameMkLst>
        </pc:graphicFrameChg>
        <pc:graphicFrameChg chg="mod">
          <ac:chgData name="OKAGAWA Tomohiro" userId="d74b3e309c52a267" providerId="LiveId" clId="{75BADE36-D135-44E3-A78F-3516F48BF828}" dt="2021-12-28T01:51:27.036" v="38" actId="1035"/>
          <ac:graphicFrameMkLst>
            <pc:docMk/>
            <pc:sldMk cId="1049214770" sldId="258"/>
            <ac:graphicFrameMk id="31" creationId="{E17D7C43-FE12-4072-B07F-E5350C93098C}"/>
          </ac:graphicFrameMkLst>
        </pc:graphicFrameChg>
        <pc:graphicFrameChg chg="mod">
          <ac:chgData name="OKAGAWA Tomohiro" userId="d74b3e309c52a267" providerId="LiveId" clId="{75BADE36-D135-44E3-A78F-3516F48BF828}" dt="2021-12-28T01:51:38.239" v="42" actId="1036"/>
          <ac:graphicFrameMkLst>
            <pc:docMk/>
            <pc:sldMk cId="1049214770" sldId="258"/>
            <ac:graphicFrameMk id="32" creationId="{95D1890E-7118-43C1-BE3A-F1140E6D1AC3}"/>
          </ac:graphicFrameMkLst>
        </pc:graphicFrameChg>
        <pc:graphicFrameChg chg="mod">
          <ac:chgData name="OKAGAWA Tomohiro" userId="d74b3e309c52a267" providerId="LiveId" clId="{75BADE36-D135-44E3-A78F-3516F48BF828}" dt="2021-12-28T01:51:38.239" v="42" actId="1036"/>
          <ac:graphicFrameMkLst>
            <pc:docMk/>
            <pc:sldMk cId="1049214770" sldId="258"/>
            <ac:graphicFrameMk id="33" creationId="{4149C239-CF2C-485B-BF44-3785E054F06B}"/>
          </ac:graphicFrameMkLst>
        </pc:graphicFrameChg>
        <pc:graphicFrameChg chg="mod">
          <ac:chgData name="OKAGAWA Tomohiro" userId="d74b3e309c52a267" providerId="LiveId" clId="{75BADE36-D135-44E3-A78F-3516F48BF828}" dt="2021-12-28T01:49:40.660" v="12"/>
          <ac:graphicFrameMkLst>
            <pc:docMk/>
            <pc:sldMk cId="1049214770" sldId="258"/>
            <ac:graphicFrameMk id="34" creationId="{062DDB20-E2D7-4D16-AD4F-919A2FFAE435}"/>
          </ac:graphicFrameMkLst>
        </pc:graphicFrameChg>
        <pc:graphicFrameChg chg="mod">
          <ac:chgData name="OKAGAWA Tomohiro" userId="d74b3e309c52a267" providerId="LiveId" clId="{75BADE36-D135-44E3-A78F-3516F48BF828}" dt="2021-12-28T01:49:43.530" v="13"/>
          <ac:graphicFrameMkLst>
            <pc:docMk/>
            <pc:sldMk cId="1049214770" sldId="258"/>
            <ac:graphicFrameMk id="35" creationId="{005F1329-1588-4275-BDAF-79CBDDFAAC74}"/>
          </ac:graphicFrameMkLst>
        </pc:graphicFrameChg>
        <pc:graphicFrameChg chg="mod">
          <ac:chgData name="OKAGAWA Tomohiro" userId="d74b3e309c52a267" providerId="LiveId" clId="{75BADE36-D135-44E3-A78F-3516F48BF828}" dt="2021-12-28T01:52:00.405" v="54" actId="1035"/>
          <ac:graphicFrameMkLst>
            <pc:docMk/>
            <pc:sldMk cId="1049214770" sldId="258"/>
            <ac:graphicFrameMk id="36" creationId="{852803FF-B353-469B-BFA8-CBF8E946285C}"/>
          </ac:graphicFrameMkLst>
        </pc:graphicFrameChg>
        <pc:graphicFrameChg chg="mod">
          <ac:chgData name="OKAGAWA Tomohiro" userId="d74b3e309c52a267" providerId="LiveId" clId="{75BADE36-D135-44E3-A78F-3516F48BF828}" dt="2021-12-28T01:51:27.036" v="38" actId="1035"/>
          <ac:graphicFrameMkLst>
            <pc:docMk/>
            <pc:sldMk cId="1049214770" sldId="258"/>
            <ac:graphicFrameMk id="37" creationId="{768778D3-03C8-42C2-B2D6-BE80D1D759DB}"/>
          </ac:graphicFrameMkLst>
        </pc:graphicFrameChg>
        <pc:graphicFrameChg chg="mod">
          <ac:chgData name="OKAGAWA Tomohiro" userId="d74b3e309c52a267" providerId="LiveId" clId="{75BADE36-D135-44E3-A78F-3516F48BF828}" dt="2021-12-28T01:51:38.239" v="42" actId="1036"/>
          <ac:graphicFrameMkLst>
            <pc:docMk/>
            <pc:sldMk cId="1049214770" sldId="258"/>
            <ac:graphicFrameMk id="38" creationId="{773C2F7C-5F1B-4EB8-85D4-F6B78F9E523E}"/>
          </ac:graphicFrameMkLst>
        </pc:graphicFrameChg>
        <pc:graphicFrameChg chg="mod">
          <ac:chgData name="OKAGAWA Tomohiro" userId="d74b3e309c52a267" providerId="LiveId" clId="{75BADE36-D135-44E3-A78F-3516F48BF828}" dt="2021-12-28T01:49:46.645" v="14"/>
          <ac:graphicFrameMkLst>
            <pc:docMk/>
            <pc:sldMk cId="1049214770" sldId="258"/>
            <ac:graphicFrameMk id="39" creationId="{00A8CE87-EB03-4E6E-8B74-FB97B57C7656}"/>
          </ac:graphicFrameMkLst>
        </pc:graphicFrameChg>
        <pc:graphicFrameChg chg="mod">
          <ac:chgData name="OKAGAWA Tomohiro" userId="d74b3e309c52a267" providerId="LiveId" clId="{75BADE36-D135-44E3-A78F-3516F48BF828}" dt="2021-12-28T01:52:00.405" v="54" actId="1035"/>
          <ac:graphicFrameMkLst>
            <pc:docMk/>
            <pc:sldMk cId="1049214770" sldId="258"/>
            <ac:graphicFrameMk id="40" creationId="{064EA0AA-C22F-49AE-9CEA-E0356656FF6F}"/>
          </ac:graphicFrameMkLst>
        </pc:graphicFrameChg>
        <pc:graphicFrameChg chg="mod">
          <ac:chgData name="OKAGAWA Tomohiro" userId="d74b3e309c52a267" providerId="LiveId" clId="{75BADE36-D135-44E3-A78F-3516F48BF828}" dt="2021-12-28T01:51:27.036" v="38" actId="1035"/>
          <ac:graphicFrameMkLst>
            <pc:docMk/>
            <pc:sldMk cId="1049214770" sldId="258"/>
            <ac:graphicFrameMk id="41" creationId="{F44D814E-1B36-4F4C-896D-050F941198C6}"/>
          </ac:graphicFrameMkLst>
        </pc:graphicFrameChg>
        <pc:graphicFrameChg chg="mod">
          <ac:chgData name="OKAGAWA Tomohiro" userId="d74b3e309c52a267" providerId="LiveId" clId="{75BADE36-D135-44E3-A78F-3516F48BF828}" dt="2021-12-28T01:51:38.239" v="42" actId="1036"/>
          <ac:graphicFrameMkLst>
            <pc:docMk/>
            <pc:sldMk cId="1049214770" sldId="258"/>
            <ac:graphicFrameMk id="42" creationId="{08DE84B1-09F9-44BE-AFED-D8B84AEA3580}"/>
          </ac:graphicFrameMkLst>
        </pc:graphicFrameChg>
        <pc:graphicFrameChg chg="mod">
          <ac:chgData name="OKAGAWA Tomohiro" userId="d74b3e309c52a267" providerId="LiveId" clId="{75BADE36-D135-44E3-A78F-3516F48BF828}" dt="2021-12-28T01:49:49.011" v="15"/>
          <ac:graphicFrameMkLst>
            <pc:docMk/>
            <pc:sldMk cId="1049214770" sldId="258"/>
            <ac:graphicFrameMk id="43" creationId="{098280B6-CF08-4590-8775-7050A3206417}"/>
          </ac:graphicFrameMkLst>
        </pc:graphicFrameChg>
        <pc:graphicFrameChg chg="mod">
          <ac:chgData name="OKAGAWA Tomohiro" userId="d74b3e309c52a267" providerId="LiveId" clId="{75BADE36-D135-44E3-A78F-3516F48BF828}" dt="2021-12-28T01:52:00.405" v="54" actId="1035"/>
          <ac:graphicFrameMkLst>
            <pc:docMk/>
            <pc:sldMk cId="1049214770" sldId="258"/>
            <ac:graphicFrameMk id="44" creationId="{835EE864-141E-4AA5-997F-45BF4B12A918}"/>
          </ac:graphicFrameMkLst>
        </pc:graphicFrameChg>
        <pc:graphicFrameChg chg="mod">
          <ac:chgData name="OKAGAWA Tomohiro" userId="d74b3e309c52a267" providerId="LiveId" clId="{75BADE36-D135-44E3-A78F-3516F48BF828}" dt="2021-12-28T01:51:38.239" v="42" actId="1036"/>
          <ac:graphicFrameMkLst>
            <pc:docMk/>
            <pc:sldMk cId="1049214770" sldId="258"/>
            <ac:graphicFrameMk id="46" creationId="{9F987B25-799C-48E5-900E-F7EF58B5E46A}"/>
          </ac:graphicFrameMkLst>
        </pc:graphicFrameChg>
        <pc:graphicFrameChg chg="mod">
          <ac:chgData name="OKAGAWA Tomohiro" userId="d74b3e309c52a267" providerId="LiveId" clId="{75BADE36-D135-44E3-A78F-3516F48BF828}" dt="2021-12-28T01:49:51.726" v="16"/>
          <ac:graphicFrameMkLst>
            <pc:docMk/>
            <pc:sldMk cId="1049214770" sldId="258"/>
            <ac:graphicFrameMk id="47" creationId="{9D4EB86F-164B-4135-A230-59F3E074F67F}"/>
          </ac:graphicFrameMkLst>
        </pc:graphicFrameChg>
        <pc:graphicFrameChg chg="mod">
          <ac:chgData name="OKAGAWA Tomohiro" userId="d74b3e309c52a267" providerId="LiveId" clId="{75BADE36-D135-44E3-A78F-3516F48BF828}" dt="2021-12-28T01:51:27.036" v="38" actId="1035"/>
          <ac:graphicFrameMkLst>
            <pc:docMk/>
            <pc:sldMk cId="1049214770" sldId="258"/>
            <ac:graphicFrameMk id="53" creationId="{E833D5E4-9383-4B5C-9543-3FAD1A76F9A5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Infectious%20Diseases\&#21608;&#29987;&#26399;&#20813;&#30123;\BLV\&#12458;&#12496;&#12507;&#12523;&#12514;&#12531;&#25237;&#19982;&#35430;&#39443;\190318%20&#12458;&#12496;&#12507;&#12523;&#12514;&#12531;&#25237;&#19982;&#35430;&#39443;%20&#12414;&#12392;&#1241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Infectious%20Diseases\&#21608;&#29987;&#26399;&#20813;&#30123;\BLV\&#12458;&#12496;&#12507;&#12523;&#12514;&#12531;&#25237;&#19982;&#35430;&#39443;\&#12458;&#12496;&#12507;&#12523;&#12514;&#12531;&#25237;&#19982;&#35430;&#39443;%20at%20&#30044;&#29987;&#35430;&#39443;&#22580;\200215%20&#12458;&#12496;&#12507;&#12523;&#12514;&#12531;&#25237;&#19982;&#35430;&#39443;%20&#12414;&#12392;&#12417;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Infectious%20Diseases\&#21608;&#29987;&#26399;&#20813;&#30123;\BLV\&#12458;&#12496;&#12507;&#12523;&#12514;&#12531;&#25237;&#19982;&#35430;&#39443;\&#12458;&#12496;&#12507;&#12523;&#12514;&#12531;&#25237;&#19982;&#35430;&#39443;%20at%20&#30044;&#29987;&#35430;&#39443;&#22580;\200215%20&#12458;&#12496;&#12507;&#12523;&#12514;&#12531;&#25237;&#19982;&#35430;&#39443;%20&#12414;&#12392;&#12417;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Infectious%20Diseases\&#21608;&#29987;&#26399;&#20813;&#30123;\BLV\&#12458;&#12496;&#12507;&#12523;&#12514;&#12531;&#25237;&#19982;&#35430;&#39443;\&#12458;&#12496;&#12507;&#12523;&#12514;&#12531;&#25237;&#19982;&#35430;&#39443;%20at%20&#30044;&#29987;&#35430;&#39443;&#22580;\200215%20&#12458;&#12496;&#12507;&#12523;&#12514;&#12531;&#25237;&#19982;&#35430;&#39443;%20&#12414;&#12392;&#12417;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Infectious%20Diseases\&#21608;&#29987;&#26399;&#20813;&#30123;\BLV\&#12458;&#12496;&#12507;&#12523;&#12514;&#12531;&#25237;&#19982;&#35430;&#39443;\&#12458;&#12496;&#12507;&#12523;&#12514;&#12531;&#25237;&#19982;&#35430;&#39443;%20at%20&#30044;&#29987;&#35430;&#39443;&#22580;\200215%20&#12458;&#12496;&#12507;&#12523;&#12514;&#12531;&#25237;&#19982;&#35430;&#39443;%20&#12414;&#12392;&#12417;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Infectious%20Diseases\&#21608;&#29987;&#26399;&#20813;&#30123;\BLV\&#12458;&#12496;&#12507;&#12523;&#12514;&#12531;&#25237;&#19982;&#35430;&#39443;\&#12458;&#12496;&#12507;&#12523;&#12514;&#12531;&#25237;&#19982;&#35430;&#39443;%20at%20&#30044;&#29987;&#35430;&#39443;&#22580;\200215%20&#12458;&#12496;&#12507;&#12523;&#12514;&#12531;&#25237;&#19982;&#35430;&#39443;%20&#12414;&#12392;&#12417;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Infectious%20Diseases\&#21608;&#29987;&#26399;&#20813;&#30123;\BLV\&#12458;&#12496;&#12507;&#12523;&#12514;&#12531;&#25237;&#19982;&#35430;&#39443;\&#12458;&#12496;&#12507;&#12523;&#12514;&#12531;&#25237;&#19982;&#35430;&#39443;%20at%20&#30044;&#29987;&#35430;&#39443;&#22580;\200215%20&#12458;&#12496;&#12507;&#12523;&#12514;&#12531;&#25237;&#19982;&#35430;&#39443;%20&#12414;&#12392;&#12417;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Infectious%20Diseases\&#21608;&#29987;&#26399;&#20813;&#30123;\BLV\&#12458;&#12496;&#12507;&#12523;&#12514;&#12531;&#25237;&#19982;&#35430;&#39443;\&#12458;&#12496;&#12507;&#12523;&#12514;&#12531;&#25237;&#19982;&#35430;&#39443;%20at%20&#30044;&#29987;&#35430;&#39443;&#22580;\200215%20&#12458;&#12496;&#12507;&#12523;&#12514;&#12531;&#25237;&#19982;&#35430;&#39443;%20&#12414;&#12392;&#12417;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Infectious%20Diseases\&#21608;&#29987;&#26399;&#20813;&#30123;\BLV\&#12458;&#12496;&#12507;&#12523;&#12514;&#12531;&#25237;&#19982;&#35430;&#39443;\&#12458;&#12496;&#12507;&#12523;&#12514;&#12531;&#25237;&#19982;&#35430;&#39443;%20at%20&#30044;&#29987;&#35430;&#39443;&#22580;\200215%20&#12458;&#12496;&#12507;&#12523;&#12514;&#12531;&#25237;&#19982;&#35430;&#39443;%20&#12414;&#12392;&#12417;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Infectious%20Diseases\&#21608;&#29987;&#26399;&#20813;&#30123;\BLV\&#12458;&#12496;&#12507;&#12523;&#12514;&#12531;&#25237;&#19982;&#35430;&#39443;\&#12458;&#12496;&#12507;&#12523;&#12514;&#12531;&#25237;&#19982;&#35430;&#39443;%20at%20&#30044;&#29987;&#35430;&#39443;&#22580;\200215%20&#12458;&#12496;&#12507;&#12523;&#12514;&#12531;&#25237;&#19982;&#35430;&#39443;%20&#12414;&#12392;&#12417;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Infectious%20Diseases\&#21608;&#29987;&#26399;&#20813;&#30123;\BLV\&#12458;&#12496;&#12507;&#12523;&#12514;&#12531;&#25237;&#19982;&#35430;&#39443;\&#12458;&#12496;&#12507;&#12523;&#12514;&#12531;&#25237;&#19982;&#35430;&#39443;%20at%20&#30044;&#29987;&#35430;&#39443;&#22580;\200215%20&#12458;&#12496;&#12507;&#12523;&#12514;&#12531;&#25237;&#19982;&#35430;&#39443;%20&#12414;&#12392;&#12417;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Infectious%20Diseases\&#21608;&#29987;&#26399;&#20813;&#30123;\BLV\&#12458;&#12496;&#12507;&#12523;&#12514;&#12531;&#25237;&#19982;&#35430;&#39443;\190318%20&#12458;&#12496;&#12507;&#12523;&#12514;&#12531;&#25237;&#19982;&#35430;&#39443;%20&#12414;&#12392;&#12417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0.xml"/><Relationship Id="rId1" Type="http://schemas.microsoft.com/office/2011/relationships/chartStyle" Target="style20.xml"/><Relationship Id="rId4" Type="http://schemas.openxmlformats.org/officeDocument/2006/relationships/package" Target="../embeddings/Microsoft_Excel_Worksheet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F:\Infectious%20Diseases\&#21608;&#29987;&#26399;&#20813;&#30123;\BLV\&#12458;&#12496;&#12507;&#12523;&#12514;&#12531;&#25237;&#19982;&#35430;&#39443;\190318%20&#12458;&#12496;&#12507;&#12523;&#12514;&#12531;&#25237;&#19982;&#35430;&#39443;%20&#12414;&#12392;&#12417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F:\Infectious%20Diseases\&#21608;&#29987;&#26399;&#20813;&#30123;\BLV\&#12458;&#12496;&#12507;&#12523;&#12514;&#12531;&#25237;&#19982;&#35430;&#39443;\190318%20&#12458;&#12496;&#12507;&#12523;&#12514;&#12531;&#25237;&#19982;&#35430;&#39443;%20&#12414;&#12392;&#12417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Infectious%20Diseases\&#21608;&#29987;&#26399;&#20813;&#30123;\BLV\&#12458;&#12496;&#12507;&#12523;&#12514;&#12531;&#25237;&#19982;&#35430;&#39443;\190318%20&#12458;&#12496;&#12507;&#12523;&#12514;&#12531;&#25237;&#19982;&#35430;&#39443;%20&#12414;&#12392;&#12417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Infectious%20Diseases\&#21608;&#29987;&#26399;&#20813;&#30123;\BLV\&#12458;&#12496;&#12507;&#12523;&#12514;&#12531;&#25237;&#19982;&#35430;&#39443;\190318%20&#12458;&#12496;&#12507;&#12523;&#12514;&#12531;&#25237;&#19982;&#35430;&#39443;%20&#12414;&#12392;&#12417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F:\Infectious%20Diseases\&#21608;&#29987;&#26399;&#20813;&#30123;\BLV\&#12458;&#12496;&#12507;&#12523;&#12514;&#12531;&#25237;&#19982;&#35430;&#39443;\190318%20&#12458;&#12496;&#12507;&#12523;&#12514;&#12531;&#25237;&#19982;&#35430;&#39443;%20&#12414;&#12392;&#12417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F:\Infectious%20Diseases\&#21608;&#29987;&#26399;&#20813;&#30123;\BLV\&#12458;&#12496;&#12507;&#12523;&#12514;&#12531;&#25237;&#19982;&#35430;&#39443;\190318%20&#12458;&#12496;&#12507;&#12523;&#12514;&#12531;&#25237;&#19982;&#35430;&#39443;%20&#12414;&#12392;&#12417;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Infectious%20Diseases\&#21608;&#29987;&#26399;&#20813;&#30123;\BLV\&#12458;&#12496;&#12507;&#12523;&#12514;&#12531;&#25237;&#19982;&#35430;&#39443;\&#12458;&#12496;&#12507;&#12523;&#12514;&#12531;&#25237;&#19982;&#35430;&#39443;%20at%20&#30044;&#29987;&#35430;&#39443;&#22580;\200215%20&#12458;&#12496;&#12507;&#12523;&#12514;&#12531;&#25237;&#19982;&#35430;&#39443;%20&#12414;&#12392;&#12417;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265930984190456"/>
          <c:y val="0.11435550400326122"/>
          <c:w val="0.64187541524377489"/>
          <c:h val="0.62673364826800937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8968-4CDA-92CA-7A89C6FF5C8C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8968-4CDA-92CA-7A89C6FF5C8C}"/>
              </c:ext>
            </c:extLst>
          </c:dPt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8968-4CDA-92CA-7A89C6FF5C8C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8968-4CDA-92CA-7A89C6FF5C8C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8968-4CDA-92CA-7A89C6FF5C8C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8968-4CDA-92CA-7A89C6FF5C8C}"/>
              </c:ext>
            </c:extLst>
          </c:dPt>
          <c:dPt>
            <c:idx val="6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8968-4CDA-92CA-7A89C6FF5C8C}"/>
              </c:ext>
            </c:extLst>
          </c:dPt>
          <c:dPt>
            <c:idx val="7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8968-4CDA-92CA-7A89C6FF5C8C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#17'!$J$31:$J$38</c:f>
                <c:numCache>
                  <c:formatCode>General</c:formatCode>
                  <c:ptCount val="8"/>
                  <c:pt idx="0">
                    <c:v>24.814883865171929</c:v>
                  </c:pt>
                  <c:pt idx="1">
                    <c:v>13.218095213991033</c:v>
                  </c:pt>
                  <c:pt idx="2">
                    <c:v>16.985459116036779</c:v>
                  </c:pt>
                  <c:pt idx="3">
                    <c:v>30.036155244908432</c:v>
                  </c:pt>
                  <c:pt idx="4">
                    <c:v>27.643635219145953</c:v>
                  </c:pt>
                  <c:pt idx="5">
                    <c:v>22.71070531473827</c:v>
                  </c:pt>
                  <c:pt idx="6">
                    <c:v>18.270409454033775</c:v>
                  </c:pt>
                  <c:pt idx="7">
                    <c:v>28.199745079760312</c:v>
                  </c:pt>
                </c:numCache>
              </c:numRef>
            </c:plus>
            <c:minus>
              <c:numRef>
                <c:f>'#17'!$J$31:$J$38</c:f>
                <c:numCache>
                  <c:formatCode>General</c:formatCode>
                  <c:ptCount val="8"/>
                  <c:pt idx="0">
                    <c:v>24.814883865171929</c:v>
                  </c:pt>
                  <c:pt idx="1">
                    <c:v>13.218095213991033</c:v>
                  </c:pt>
                  <c:pt idx="2">
                    <c:v>16.985459116036779</c:v>
                  </c:pt>
                  <c:pt idx="3">
                    <c:v>30.036155244908432</c:v>
                  </c:pt>
                  <c:pt idx="4">
                    <c:v>27.643635219145953</c:v>
                  </c:pt>
                  <c:pt idx="5">
                    <c:v>22.71070531473827</c:v>
                  </c:pt>
                  <c:pt idx="6">
                    <c:v>18.270409454033775</c:v>
                  </c:pt>
                  <c:pt idx="7">
                    <c:v>28.1997450797603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#17'!$B$7:$B$1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#17'!$I$31:$I$38</c:f>
              <c:numCache>
                <c:formatCode>General</c:formatCode>
                <c:ptCount val="8"/>
                <c:pt idx="0">
                  <c:v>103.68760186469429</c:v>
                </c:pt>
                <c:pt idx="1">
                  <c:v>234.06275862864211</c:v>
                </c:pt>
                <c:pt idx="2">
                  <c:v>398.51035000008523</c:v>
                </c:pt>
                <c:pt idx="3">
                  <c:v>411.17763420831653</c:v>
                </c:pt>
                <c:pt idx="4">
                  <c:v>642.8017063318083</c:v>
                </c:pt>
                <c:pt idx="5">
                  <c:v>335.39984379114145</c:v>
                </c:pt>
                <c:pt idx="6">
                  <c:v>333.19229128501678</c:v>
                </c:pt>
                <c:pt idx="7">
                  <c:v>96.7205980140742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8968-4CDA-92CA-7A89C6FF5C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tradiol</a:t>
                </a:r>
                <a:r>
                  <a:rPr lang="en-US" altLang="ja-JP" sz="6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5.4386993127294926E-2"/>
              <c:y val="0.110942707264126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766133377350205"/>
          <c:y val="0.11563296425145245"/>
          <c:w val="0.63532229381884775"/>
          <c:h val="0.62256390645731885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L#1'!$J$7:$J$14</c:f>
                <c:numCache>
                  <c:formatCode>General</c:formatCode>
                  <c:ptCount val="8"/>
                  <c:pt idx="0">
                    <c:v>7.2721391554254069</c:v>
                  </c:pt>
                  <c:pt idx="1">
                    <c:v>10.017297083348241</c:v>
                  </c:pt>
                  <c:pt idx="2">
                    <c:v>12.521956540517079</c:v>
                  </c:pt>
                  <c:pt idx="3">
                    <c:v>3.8926693310766609</c:v>
                  </c:pt>
                  <c:pt idx="4">
                    <c:v>13.058383040743664</c:v>
                  </c:pt>
                  <c:pt idx="5">
                    <c:v>3.9450336819315623</c:v>
                  </c:pt>
                  <c:pt idx="6">
                    <c:v>19.083624275014586</c:v>
                  </c:pt>
                  <c:pt idx="7">
                    <c:v>11.210876362633623</c:v>
                  </c:pt>
                </c:numCache>
              </c:numRef>
            </c:plus>
            <c:minus>
              <c:numRef>
                <c:f>'PL#1'!$J$7:$J$14</c:f>
                <c:numCache>
                  <c:formatCode>General</c:formatCode>
                  <c:ptCount val="8"/>
                  <c:pt idx="0">
                    <c:v>7.2721391554254069</c:v>
                  </c:pt>
                  <c:pt idx="1">
                    <c:v>10.017297083348241</c:v>
                  </c:pt>
                  <c:pt idx="2">
                    <c:v>12.521956540517079</c:v>
                  </c:pt>
                  <c:pt idx="3">
                    <c:v>3.8926693310766609</c:v>
                  </c:pt>
                  <c:pt idx="4">
                    <c:v>13.058383040743664</c:v>
                  </c:pt>
                  <c:pt idx="5">
                    <c:v>3.9450336819315623</c:v>
                  </c:pt>
                  <c:pt idx="6">
                    <c:v>19.083624275014586</c:v>
                  </c:pt>
                  <c:pt idx="7">
                    <c:v>11.2108763626336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PL#1'!$B$7:$B$1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PL#1'!$I$7:$I$14</c:f>
              <c:numCache>
                <c:formatCode>General</c:formatCode>
                <c:ptCount val="8"/>
                <c:pt idx="0">
                  <c:v>86.11942833710593</c:v>
                </c:pt>
                <c:pt idx="1">
                  <c:v>65.624175653531125</c:v>
                </c:pt>
                <c:pt idx="2">
                  <c:v>99.066105629013265</c:v>
                </c:pt>
                <c:pt idx="3">
                  <c:v>84.90777754737546</c:v>
                </c:pt>
                <c:pt idx="4">
                  <c:v>251.80571721337088</c:v>
                </c:pt>
                <c:pt idx="5">
                  <c:v>222.55044330017304</c:v>
                </c:pt>
                <c:pt idx="6">
                  <c:v>213.47384720362516</c:v>
                </c:pt>
                <c:pt idx="7">
                  <c:v>108.115934042491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A61-4322-AE07-7BD3DEB5C3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E</a:t>
                </a:r>
                <a:r>
                  <a:rPr lang="en-US" altLang="ja-JP" sz="600" baseline="-25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ja-JP" sz="6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553731208481136"/>
          <c:y val="0.11563286853941698"/>
          <c:w val="0.63744631550753839"/>
          <c:h val="0.63307629782788999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L#1'!$O$7:$O$14</c:f>
                <c:numCache>
                  <c:formatCode>General</c:formatCode>
                  <c:ptCount val="8"/>
                  <c:pt idx="0">
                    <c:v>0.31877631354324532</c:v>
                  </c:pt>
                  <c:pt idx="1">
                    <c:v>4.7102002804787629E-2</c:v>
                  </c:pt>
                  <c:pt idx="2">
                    <c:v>0.10578640797695459</c:v>
                  </c:pt>
                  <c:pt idx="3">
                    <c:v>5.5863701454721235E-2</c:v>
                  </c:pt>
                  <c:pt idx="4">
                    <c:v>0.1380803953290328</c:v>
                  </c:pt>
                  <c:pt idx="5">
                    <c:v>0.1314696079970154</c:v>
                  </c:pt>
                  <c:pt idx="6">
                    <c:v>6.489281447809836E-2</c:v>
                  </c:pt>
                  <c:pt idx="7">
                    <c:v>9.5595091583662875E-2</c:v>
                  </c:pt>
                </c:numCache>
              </c:numRef>
            </c:plus>
            <c:minus>
              <c:numRef>
                <c:f>'PL#1'!$O$7:$O$14</c:f>
                <c:numCache>
                  <c:formatCode>General</c:formatCode>
                  <c:ptCount val="8"/>
                  <c:pt idx="0">
                    <c:v>0.31877631354324532</c:v>
                  </c:pt>
                  <c:pt idx="1">
                    <c:v>4.7102002804787629E-2</c:v>
                  </c:pt>
                  <c:pt idx="2">
                    <c:v>0.10578640797695459</c:v>
                  </c:pt>
                  <c:pt idx="3">
                    <c:v>5.5863701454721235E-2</c:v>
                  </c:pt>
                  <c:pt idx="4">
                    <c:v>0.1380803953290328</c:v>
                  </c:pt>
                  <c:pt idx="5">
                    <c:v>0.1314696079970154</c:v>
                  </c:pt>
                  <c:pt idx="6">
                    <c:v>6.489281447809836E-2</c:v>
                  </c:pt>
                  <c:pt idx="7">
                    <c:v>9.559509158366287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PL#1'!$B$7:$B$1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PL#1'!$N$7:$N$14</c:f>
              <c:numCache>
                <c:formatCode>General</c:formatCode>
                <c:ptCount val="8"/>
                <c:pt idx="0">
                  <c:v>3.0277396666666667</c:v>
                </c:pt>
                <c:pt idx="1">
                  <c:v>1.8546446666666665</c:v>
                </c:pt>
                <c:pt idx="2">
                  <c:v>1.2308000000000001</c:v>
                </c:pt>
                <c:pt idx="3">
                  <c:v>1.0792303333333333</c:v>
                </c:pt>
                <c:pt idx="4">
                  <c:v>1.3173453333333336</c:v>
                </c:pt>
                <c:pt idx="5">
                  <c:v>1.3318786666666667</c:v>
                </c:pt>
                <c:pt idx="6">
                  <c:v>0.80778333333333341</c:v>
                </c:pt>
                <c:pt idx="7">
                  <c:v>1.90028133333333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459-40CD-B446-01F23C0395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ng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10199664267539529"/>
              <c:y val="0.1650851643940158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766133377350205"/>
          <c:y val="0.11536301777102465"/>
          <c:w val="0.63532229381884775"/>
          <c:h val="0.64442012948404559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L#1'!$O$19:$O$26</c:f>
                <c:numCache>
                  <c:formatCode>General</c:formatCode>
                  <c:ptCount val="8"/>
                  <c:pt idx="0">
                    <c:v>149.64499999999992</c:v>
                  </c:pt>
                  <c:pt idx="1">
                    <c:v>4.8910000000000053</c:v>
                  </c:pt>
                  <c:pt idx="2">
                    <c:v>15.329999999999998</c:v>
                  </c:pt>
                  <c:pt idx="3">
                    <c:v>44.39099999999997</c:v>
                  </c:pt>
                  <c:pt idx="4">
                    <c:v>5.6980000000000004</c:v>
                  </c:pt>
                  <c:pt idx="5">
                    <c:v>0.22499999999999964</c:v>
                  </c:pt>
                  <c:pt idx="6">
                    <c:v>2.6355000000000004</c:v>
                  </c:pt>
                  <c:pt idx="7">
                    <c:v>5.8245000000000005</c:v>
                  </c:pt>
                </c:numCache>
              </c:numRef>
            </c:plus>
            <c:minus>
              <c:numRef>
                <c:f>'PL#1'!$O$19:$O$26</c:f>
                <c:numCache>
                  <c:formatCode>General</c:formatCode>
                  <c:ptCount val="8"/>
                  <c:pt idx="0">
                    <c:v>149.64499999999992</c:v>
                  </c:pt>
                  <c:pt idx="1">
                    <c:v>4.8910000000000053</c:v>
                  </c:pt>
                  <c:pt idx="2">
                    <c:v>15.329999999999998</c:v>
                  </c:pt>
                  <c:pt idx="3">
                    <c:v>44.39099999999997</c:v>
                  </c:pt>
                  <c:pt idx="4">
                    <c:v>5.6980000000000004</c:v>
                  </c:pt>
                  <c:pt idx="5">
                    <c:v>0.22499999999999964</c:v>
                  </c:pt>
                  <c:pt idx="6">
                    <c:v>2.6355000000000004</c:v>
                  </c:pt>
                  <c:pt idx="7">
                    <c:v>5.82450000000000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L#1'!$B$19:$B$26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PL#1'!$N$19:$N$26</c:f>
              <c:numCache>
                <c:formatCode>General</c:formatCode>
                <c:ptCount val="8"/>
                <c:pt idx="0">
                  <c:v>354.08000000000004</c:v>
                </c:pt>
                <c:pt idx="1">
                  <c:v>157.29500000000002</c:v>
                </c:pt>
                <c:pt idx="2">
                  <c:v>185.78800000000001</c:v>
                </c:pt>
                <c:pt idx="3">
                  <c:v>177.89400000000001</c:v>
                </c:pt>
                <c:pt idx="4">
                  <c:v>88.443999999999988</c:v>
                </c:pt>
                <c:pt idx="5">
                  <c:v>28.399000000000001</c:v>
                </c:pt>
                <c:pt idx="6">
                  <c:v>63.287500000000001</c:v>
                </c:pt>
                <c:pt idx="7">
                  <c:v>149.5415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9E5-4C76-8A1D-73C01A4334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766133377350205"/>
          <c:y val="0.11536311303685756"/>
          <c:w val="0.63532229381884775"/>
          <c:h val="0.63393228011848457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L#2'!$J$31:$J$38</c:f>
                <c:numCache>
                  <c:formatCode>General</c:formatCode>
                  <c:ptCount val="8"/>
                  <c:pt idx="0">
                    <c:v>0.86918901706543039</c:v>
                  </c:pt>
                  <c:pt idx="1">
                    <c:v>3.9029537134606613</c:v>
                  </c:pt>
                  <c:pt idx="2">
                    <c:v>4.8690433837167433</c:v>
                  </c:pt>
                  <c:pt idx="3">
                    <c:v>4.4727234394084263</c:v>
                  </c:pt>
                  <c:pt idx="4">
                    <c:v>8.2955373617700161</c:v>
                  </c:pt>
                  <c:pt idx="5">
                    <c:v>2.8021846666843686</c:v>
                  </c:pt>
                  <c:pt idx="6">
                    <c:v>2.6545489660079795</c:v>
                  </c:pt>
                  <c:pt idx="7">
                    <c:v>8.6268456407301528</c:v>
                  </c:pt>
                </c:numCache>
              </c:numRef>
            </c:plus>
            <c:minus>
              <c:numRef>
                <c:f>'PL#2'!$J$31:$J$38</c:f>
                <c:numCache>
                  <c:formatCode>General</c:formatCode>
                  <c:ptCount val="8"/>
                  <c:pt idx="0">
                    <c:v>0.86918901706543039</c:v>
                  </c:pt>
                  <c:pt idx="1">
                    <c:v>3.9029537134606613</c:v>
                  </c:pt>
                  <c:pt idx="2">
                    <c:v>4.8690433837167433</c:v>
                  </c:pt>
                  <c:pt idx="3">
                    <c:v>4.4727234394084263</c:v>
                  </c:pt>
                  <c:pt idx="4">
                    <c:v>8.2955373617700161</c:v>
                  </c:pt>
                  <c:pt idx="5">
                    <c:v>2.8021846666843686</c:v>
                  </c:pt>
                  <c:pt idx="6">
                    <c:v>2.6545489660079795</c:v>
                  </c:pt>
                  <c:pt idx="7">
                    <c:v>8.62684564073015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PL#2'!$B$31:$B$38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PL#2'!$I$31:$I$38</c:f>
              <c:numCache>
                <c:formatCode>General</c:formatCode>
                <c:ptCount val="8"/>
                <c:pt idx="0">
                  <c:v>79.58485122924489</c:v>
                </c:pt>
                <c:pt idx="1">
                  <c:v>147.90347422940096</c:v>
                </c:pt>
                <c:pt idx="2">
                  <c:v>194.44235016355304</c:v>
                </c:pt>
                <c:pt idx="3">
                  <c:v>175.77017862803274</c:v>
                </c:pt>
                <c:pt idx="4">
                  <c:v>160.10196530463165</c:v>
                </c:pt>
                <c:pt idx="5">
                  <c:v>162.73504689970707</c:v>
                </c:pt>
                <c:pt idx="6">
                  <c:v>151.82422988133754</c:v>
                </c:pt>
                <c:pt idx="7">
                  <c:v>94.4238148763247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42E-4DA5-996F-594D15FC43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tradiol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786076890782995"/>
          <c:y val="0.11536301777102465"/>
          <c:w val="0.64512291288526669"/>
          <c:h val="0.64442012948404559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L#2'!$J$7:$J$14</c:f>
                <c:numCache>
                  <c:formatCode>General</c:formatCode>
                  <c:ptCount val="8"/>
                  <c:pt idx="0">
                    <c:v>6.8691013477284741</c:v>
                  </c:pt>
                  <c:pt idx="1">
                    <c:v>2.7175934491201303</c:v>
                  </c:pt>
                  <c:pt idx="2">
                    <c:v>4.3961608854915255</c:v>
                  </c:pt>
                  <c:pt idx="3">
                    <c:v>1.4025357700266881</c:v>
                  </c:pt>
                  <c:pt idx="4">
                    <c:v>6.6832037131542279</c:v>
                  </c:pt>
                  <c:pt idx="5">
                    <c:v>15.564685984953769</c:v>
                  </c:pt>
                  <c:pt idx="6">
                    <c:v>11.993333633168731</c:v>
                  </c:pt>
                  <c:pt idx="7">
                    <c:v>1.6873931563198212</c:v>
                  </c:pt>
                </c:numCache>
              </c:numRef>
            </c:plus>
            <c:minus>
              <c:numRef>
                <c:f>'PL#2'!$J$7:$J$14</c:f>
                <c:numCache>
                  <c:formatCode>General</c:formatCode>
                  <c:ptCount val="8"/>
                  <c:pt idx="0">
                    <c:v>6.8691013477284741</c:v>
                  </c:pt>
                  <c:pt idx="1">
                    <c:v>2.7175934491201303</c:v>
                  </c:pt>
                  <c:pt idx="2">
                    <c:v>4.3961608854915255</c:v>
                  </c:pt>
                  <c:pt idx="3">
                    <c:v>1.4025357700266881</c:v>
                  </c:pt>
                  <c:pt idx="4">
                    <c:v>6.6832037131542279</c:v>
                  </c:pt>
                  <c:pt idx="5">
                    <c:v>15.564685984953769</c:v>
                  </c:pt>
                  <c:pt idx="6">
                    <c:v>11.993333633168731</c:v>
                  </c:pt>
                  <c:pt idx="7">
                    <c:v>1.68739315631982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PL#2'!$B$7:$B$1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PL#2'!$I$7:$I$14</c:f>
              <c:numCache>
                <c:formatCode>General</c:formatCode>
                <c:ptCount val="8"/>
                <c:pt idx="0">
                  <c:v>75.239218891201517</c:v>
                </c:pt>
                <c:pt idx="1">
                  <c:v>80.490195051927884</c:v>
                </c:pt>
                <c:pt idx="2">
                  <c:v>109.74103026409765</c:v>
                </c:pt>
                <c:pt idx="3">
                  <c:v>134.25863779621801</c:v>
                </c:pt>
                <c:pt idx="4">
                  <c:v>521.61132931926682</c:v>
                </c:pt>
                <c:pt idx="5">
                  <c:v>819.41048998830388</c:v>
                </c:pt>
                <c:pt idx="6">
                  <c:v>669.04599067363563</c:v>
                </c:pt>
                <c:pt idx="7">
                  <c:v>87.1130537221322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8A1-4733-A807-0B8585A376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3006529026824943"/>
              <c:y val="0.8437355486556119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E</a:t>
                </a:r>
                <a:r>
                  <a:rPr lang="en-US" altLang="ja-JP" sz="600" baseline="-25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590191504536124"/>
          <c:y val="0.11563286853941698"/>
          <c:w val="0.66708171254698834"/>
          <c:h val="0.63307629782788999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L#2'!$O$7:$O$14</c:f>
                <c:numCache>
                  <c:formatCode>General</c:formatCode>
                  <c:ptCount val="8"/>
                  <c:pt idx="0">
                    <c:v>0.67902990856662537</c:v>
                  </c:pt>
                  <c:pt idx="1">
                    <c:v>0.2182148128931666</c:v>
                  </c:pt>
                  <c:pt idx="2">
                    <c:v>2.2583886502450298E-2</c:v>
                  </c:pt>
                  <c:pt idx="3">
                    <c:v>0.15912038253333735</c:v>
                  </c:pt>
                  <c:pt idx="4">
                    <c:v>8.5797098987475465E-2</c:v>
                  </c:pt>
                  <c:pt idx="5">
                    <c:v>0.14228479004291245</c:v>
                  </c:pt>
                  <c:pt idx="6">
                    <c:v>0.1621886964461115</c:v>
                  </c:pt>
                  <c:pt idx="7">
                    <c:v>0.18408541816414117</c:v>
                  </c:pt>
                </c:numCache>
              </c:numRef>
            </c:plus>
            <c:minus>
              <c:numRef>
                <c:f>'PL#2'!$O$7:$O$14</c:f>
                <c:numCache>
                  <c:formatCode>General</c:formatCode>
                  <c:ptCount val="8"/>
                  <c:pt idx="0">
                    <c:v>0.67902990856662537</c:v>
                  </c:pt>
                  <c:pt idx="1">
                    <c:v>0.2182148128931666</c:v>
                  </c:pt>
                  <c:pt idx="2">
                    <c:v>2.2583886502450298E-2</c:v>
                  </c:pt>
                  <c:pt idx="3">
                    <c:v>0.15912038253333735</c:v>
                  </c:pt>
                  <c:pt idx="4">
                    <c:v>8.5797098987475465E-2</c:v>
                  </c:pt>
                  <c:pt idx="5">
                    <c:v>0.14228479004291245</c:v>
                  </c:pt>
                  <c:pt idx="6">
                    <c:v>0.1621886964461115</c:v>
                  </c:pt>
                  <c:pt idx="7">
                    <c:v>0.184085418164141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PL#2'!$B$7:$B$1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PL#2'!$N$7:$N$14</c:f>
              <c:numCache>
                <c:formatCode>General</c:formatCode>
                <c:ptCount val="8"/>
                <c:pt idx="0">
                  <c:v>2.2680250000000002</c:v>
                </c:pt>
                <c:pt idx="1">
                  <c:v>1.8392970000000002</c:v>
                </c:pt>
                <c:pt idx="2">
                  <c:v>0.7451053333333334</c:v>
                </c:pt>
                <c:pt idx="3">
                  <c:v>0.92246633333333339</c:v>
                </c:pt>
                <c:pt idx="4">
                  <c:v>0.89218500000000001</c:v>
                </c:pt>
                <c:pt idx="5">
                  <c:v>0.99195466666666665</c:v>
                </c:pt>
                <c:pt idx="6">
                  <c:v>1.9225446666666663</c:v>
                </c:pt>
                <c:pt idx="7">
                  <c:v>1.3937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867-4D31-8DB6-D2E816FFC0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ng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766116082384584"/>
          <c:y val="0.11536301777102465"/>
          <c:w val="0.6353225209692509"/>
          <c:h val="0.61295748827376628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L#2'!$O$19:$O$26</c:f>
                <c:numCache>
                  <c:formatCode>General</c:formatCode>
                  <c:ptCount val="8"/>
                  <c:pt idx="0">
                    <c:v>4.0560000000000045</c:v>
                  </c:pt>
                  <c:pt idx="1">
                    <c:v>0.39750000000000085</c:v>
                  </c:pt>
                  <c:pt idx="2">
                    <c:v>1.3424999999999994</c:v>
                  </c:pt>
                  <c:pt idx="3">
                    <c:v>10.643999999999949</c:v>
                  </c:pt>
                  <c:pt idx="4">
                    <c:v>5.2815000000000012</c:v>
                  </c:pt>
                  <c:pt idx="5">
                    <c:v>0.28999999999999915</c:v>
                  </c:pt>
                  <c:pt idx="6">
                    <c:v>5.0374999999999979</c:v>
                  </c:pt>
                  <c:pt idx="7">
                    <c:v>2.9635000000000034</c:v>
                  </c:pt>
                </c:numCache>
              </c:numRef>
            </c:plus>
            <c:minus>
              <c:numRef>
                <c:f>'PL#2'!$O$19:$O$26</c:f>
                <c:numCache>
                  <c:formatCode>General</c:formatCode>
                  <c:ptCount val="8"/>
                  <c:pt idx="0">
                    <c:v>4.0560000000000045</c:v>
                  </c:pt>
                  <c:pt idx="1">
                    <c:v>0.39750000000000085</c:v>
                  </c:pt>
                  <c:pt idx="2">
                    <c:v>1.3424999999999994</c:v>
                  </c:pt>
                  <c:pt idx="3">
                    <c:v>10.643999999999949</c:v>
                  </c:pt>
                  <c:pt idx="4">
                    <c:v>5.2815000000000012</c:v>
                  </c:pt>
                  <c:pt idx="5">
                    <c:v>0.28999999999999915</c:v>
                  </c:pt>
                  <c:pt idx="6">
                    <c:v>5.0374999999999979</c:v>
                  </c:pt>
                  <c:pt idx="7">
                    <c:v>2.96350000000000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L#2'!$B$19:$B$26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PL#2'!$N$19:$N$26</c:f>
              <c:numCache>
                <c:formatCode>General</c:formatCode>
                <c:ptCount val="8"/>
                <c:pt idx="0">
                  <c:v>99.259999999999991</c:v>
                </c:pt>
                <c:pt idx="1">
                  <c:v>37.641500000000001</c:v>
                </c:pt>
                <c:pt idx="2">
                  <c:v>18.991500000000002</c:v>
                </c:pt>
                <c:pt idx="3">
                  <c:v>83.02000000000001</c:v>
                </c:pt>
                <c:pt idx="4">
                  <c:v>57.6295</c:v>
                </c:pt>
                <c:pt idx="5">
                  <c:v>49.935000000000002</c:v>
                </c:pt>
                <c:pt idx="6">
                  <c:v>51.573499999999996</c:v>
                </c:pt>
                <c:pt idx="7">
                  <c:v>78.8414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1D8-460A-BDD3-7EC73CB4C5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4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392927950907129"/>
          <c:y val="0.11536301777102465"/>
          <c:w val="0.65905445648470473"/>
          <c:h val="0.63393258241395256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L#3'!$J$31:$J$38</c:f>
                <c:numCache>
                  <c:formatCode>General</c:formatCode>
                  <c:ptCount val="8"/>
                  <c:pt idx="0">
                    <c:v>4.9710433476537546</c:v>
                  </c:pt>
                  <c:pt idx="1">
                    <c:v>1.3542966617609835</c:v>
                  </c:pt>
                  <c:pt idx="2">
                    <c:v>26.645150060538519</c:v>
                  </c:pt>
                  <c:pt idx="3">
                    <c:v>3.2692647174041838</c:v>
                  </c:pt>
                  <c:pt idx="4">
                    <c:v>16.845938983566754</c:v>
                  </c:pt>
                  <c:pt idx="5">
                    <c:v>18.400866275763377</c:v>
                  </c:pt>
                  <c:pt idx="6">
                    <c:v>7.8878439614548341</c:v>
                  </c:pt>
                  <c:pt idx="7">
                    <c:v>2.2979091529449605</c:v>
                  </c:pt>
                </c:numCache>
              </c:numRef>
            </c:plus>
            <c:minus>
              <c:numRef>
                <c:f>'PL#3'!$J$31:$J$38</c:f>
                <c:numCache>
                  <c:formatCode>General</c:formatCode>
                  <c:ptCount val="8"/>
                  <c:pt idx="0">
                    <c:v>4.9710433476537546</c:v>
                  </c:pt>
                  <c:pt idx="1">
                    <c:v>1.3542966617609835</c:v>
                  </c:pt>
                  <c:pt idx="2">
                    <c:v>26.645150060538519</c:v>
                  </c:pt>
                  <c:pt idx="3">
                    <c:v>3.2692647174041838</c:v>
                  </c:pt>
                  <c:pt idx="4">
                    <c:v>16.845938983566754</c:v>
                  </c:pt>
                  <c:pt idx="5">
                    <c:v>18.400866275763377</c:v>
                  </c:pt>
                  <c:pt idx="6">
                    <c:v>7.8878439614548341</c:v>
                  </c:pt>
                  <c:pt idx="7">
                    <c:v>2.29790915294496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L#3'!$B$31:$B$38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PL#3'!$I$31:$I$38</c:f>
              <c:numCache>
                <c:formatCode>General</c:formatCode>
                <c:ptCount val="8"/>
                <c:pt idx="0">
                  <c:v>100.11760278174336</c:v>
                </c:pt>
                <c:pt idx="1">
                  <c:v>155.83307550910649</c:v>
                </c:pt>
                <c:pt idx="2">
                  <c:v>216.2184568403749</c:v>
                </c:pt>
                <c:pt idx="3">
                  <c:v>196.04212882986559</c:v>
                </c:pt>
                <c:pt idx="4">
                  <c:v>203.26497129005034</c:v>
                </c:pt>
                <c:pt idx="5">
                  <c:v>201.71004399785372</c:v>
                </c:pt>
                <c:pt idx="6">
                  <c:v>188.130746028896</c:v>
                </c:pt>
                <c:pt idx="7">
                  <c:v>124.6451183694888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D7D-458C-81DD-3F79337A26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tradiol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5.4596632588930064E-2"/>
              <c:y val="0.1378649996696835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148242904184503"/>
          <c:y val="0.11484218037374265"/>
          <c:w val="0.66229072089226571"/>
          <c:h val="0.62514509409331398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L#3'!$O$7:$O$14</c:f>
                <c:numCache>
                  <c:formatCode>General</c:formatCode>
                  <c:ptCount val="8"/>
                  <c:pt idx="0">
                    <c:v>6.4593556424426241E-2</c:v>
                  </c:pt>
                  <c:pt idx="1">
                    <c:v>2.0316723117230803E-2</c:v>
                  </c:pt>
                  <c:pt idx="2">
                    <c:v>2.0316723117230803E-2</c:v>
                  </c:pt>
                  <c:pt idx="3">
                    <c:v>5.7723237171485448E-2</c:v>
                  </c:pt>
                  <c:pt idx="4">
                    <c:v>4.3161039038569118E-2</c:v>
                  </c:pt>
                  <c:pt idx="5">
                    <c:v>2.8286607506419339E-2</c:v>
                  </c:pt>
                  <c:pt idx="6">
                    <c:v>3.2896619120443837E-2</c:v>
                  </c:pt>
                  <c:pt idx="7">
                    <c:v>9.253150247828526E-2</c:v>
                  </c:pt>
                </c:numCache>
              </c:numRef>
            </c:plus>
            <c:minus>
              <c:numRef>
                <c:f>'PL#3'!$O$7:$O$14</c:f>
                <c:numCache>
                  <c:formatCode>General</c:formatCode>
                  <c:ptCount val="8"/>
                  <c:pt idx="0">
                    <c:v>6.4593556424426241E-2</c:v>
                  </c:pt>
                  <c:pt idx="1">
                    <c:v>2.0316723117230803E-2</c:v>
                  </c:pt>
                  <c:pt idx="2">
                    <c:v>2.0316723117230803E-2</c:v>
                  </c:pt>
                  <c:pt idx="3">
                    <c:v>5.7723237171485448E-2</c:v>
                  </c:pt>
                  <c:pt idx="4">
                    <c:v>4.3161039038569118E-2</c:v>
                  </c:pt>
                  <c:pt idx="5">
                    <c:v>2.8286607506419339E-2</c:v>
                  </c:pt>
                  <c:pt idx="6">
                    <c:v>3.2896619120443837E-2</c:v>
                  </c:pt>
                  <c:pt idx="7">
                    <c:v>9.25315024782852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PL#3'!$B$7:$B$1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PL#3'!$N$7:$N$14</c:f>
              <c:numCache>
                <c:formatCode>General</c:formatCode>
                <c:ptCount val="8"/>
                <c:pt idx="0">
                  <c:v>3.7887376666666666</c:v>
                </c:pt>
                <c:pt idx="1">
                  <c:v>3.544726666666667</c:v>
                </c:pt>
                <c:pt idx="2">
                  <c:v>3.544726666666667</c:v>
                </c:pt>
                <c:pt idx="3">
                  <c:v>2.4613346666666667</c:v>
                </c:pt>
                <c:pt idx="4">
                  <c:v>0.49092966666666671</c:v>
                </c:pt>
                <c:pt idx="5">
                  <c:v>0.23723066666666667</c:v>
                </c:pt>
                <c:pt idx="6">
                  <c:v>1.4522313333333334</c:v>
                </c:pt>
                <c:pt idx="7">
                  <c:v>2.83083666666666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2EA-4004-AF03-30E9260B47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ng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5.4871631860111285E-2"/>
              <c:y val="0.1778154830605728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727591217087848"/>
          <c:y val="0.11536301777102465"/>
          <c:w val="0.64649729098488651"/>
          <c:h val="0.61295748827376628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L#3'!$O$19:$O$26</c:f>
                <c:numCache>
                  <c:formatCode>General</c:formatCode>
                  <c:ptCount val="8"/>
                  <c:pt idx="0">
                    <c:v>18.661586767117829</c:v>
                  </c:pt>
                  <c:pt idx="1">
                    <c:v>16.915044506789403</c:v>
                  </c:pt>
                  <c:pt idx="2">
                    <c:v>13.656788405608237</c:v>
                  </c:pt>
                  <c:pt idx="3">
                    <c:v>2.4860268613905894</c:v>
                  </c:pt>
                  <c:pt idx="4">
                    <c:v>9.1266648648646864</c:v>
                  </c:pt>
                  <c:pt idx="5">
                    <c:v>5.2265001886752325</c:v>
                  </c:pt>
                  <c:pt idx="6">
                    <c:v>6.1997769852363769</c:v>
                  </c:pt>
                  <c:pt idx="7">
                    <c:v>9.429877706288428</c:v>
                  </c:pt>
                </c:numCache>
              </c:numRef>
            </c:plus>
            <c:minus>
              <c:numRef>
                <c:f>'PL#3'!$O$19:$O$26</c:f>
                <c:numCache>
                  <c:formatCode>General</c:formatCode>
                  <c:ptCount val="8"/>
                  <c:pt idx="0">
                    <c:v>18.661586767117829</c:v>
                  </c:pt>
                  <c:pt idx="1">
                    <c:v>16.915044506789403</c:v>
                  </c:pt>
                  <c:pt idx="2">
                    <c:v>13.656788405608237</c:v>
                  </c:pt>
                  <c:pt idx="3">
                    <c:v>2.4860268613905894</c:v>
                  </c:pt>
                  <c:pt idx="4">
                    <c:v>9.1266648648646864</c:v>
                  </c:pt>
                  <c:pt idx="5">
                    <c:v>5.2265001886752325</c:v>
                  </c:pt>
                  <c:pt idx="6">
                    <c:v>6.1997769852363769</c:v>
                  </c:pt>
                  <c:pt idx="7">
                    <c:v>9.4298777062884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L#3'!$B$19:$B$26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PL#3'!$N$19:$N$26</c:f>
              <c:numCache>
                <c:formatCode>General</c:formatCode>
                <c:ptCount val="8"/>
                <c:pt idx="0">
                  <c:v>150.904</c:v>
                </c:pt>
                <c:pt idx="1">
                  <c:v>38.048000000000002</c:v>
                </c:pt>
                <c:pt idx="2">
                  <c:v>19.285666666666668</c:v>
                </c:pt>
                <c:pt idx="3">
                  <c:v>22.672666666666668</c:v>
                </c:pt>
                <c:pt idx="4">
                  <c:v>15.020666666666665</c:v>
                </c:pt>
                <c:pt idx="5">
                  <c:v>42.68866666666667</c:v>
                </c:pt>
                <c:pt idx="6">
                  <c:v>62.194999999999993</c:v>
                </c:pt>
                <c:pt idx="7">
                  <c:v>96.6316666666666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0B7-4729-9804-2942EF42D7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6.2710397704898196E-2"/>
              <c:y val="0.176354297416925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766133377350205"/>
          <c:y val="0.11536311303685756"/>
          <c:w val="0.63532229381884775"/>
          <c:h val="0.63393228011848457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9E8C-492A-BA16-EE9E61E604E0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9E8C-492A-BA16-EE9E61E604E0}"/>
              </c:ext>
            </c:extLst>
          </c:dPt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9E8C-492A-BA16-EE9E61E604E0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9E8C-492A-BA16-EE9E61E604E0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9E8C-492A-BA16-EE9E61E604E0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9E8C-492A-BA16-EE9E61E604E0}"/>
              </c:ext>
            </c:extLst>
          </c:dPt>
          <c:dPt>
            <c:idx val="6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9E8C-492A-BA16-EE9E61E604E0}"/>
              </c:ext>
            </c:extLst>
          </c:dPt>
          <c:dPt>
            <c:idx val="7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9E8C-492A-BA16-EE9E61E604E0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#20'!$J$31:$J$38</c:f>
                <c:numCache>
                  <c:formatCode>General</c:formatCode>
                  <c:ptCount val="8"/>
                  <c:pt idx="0">
                    <c:v>7.8609698682684863</c:v>
                  </c:pt>
                  <c:pt idx="1">
                    <c:v>4.549671466442561</c:v>
                  </c:pt>
                  <c:pt idx="2">
                    <c:v>17.896367645848855</c:v>
                  </c:pt>
                  <c:pt idx="3">
                    <c:v>21.656062874416971</c:v>
                  </c:pt>
                  <c:pt idx="4">
                    <c:v>34.254557436753537</c:v>
                  </c:pt>
                  <c:pt idx="5">
                    <c:v>24.38022875874649</c:v>
                  </c:pt>
                  <c:pt idx="6">
                    <c:v>18.899997023216567</c:v>
                  </c:pt>
                  <c:pt idx="7">
                    <c:v>55.042817001992248</c:v>
                  </c:pt>
                </c:numCache>
              </c:numRef>
            </c:plus>
            <c:minus>
              <c:numRef>
                <c:f>'#20'!$J$31:$J$38</c:f>
                <c:numCache>
                  <c:formatCode>General</c:formatCode>
                  <c:ptCount val="8"/>
                  <c:pt idx="0">
                    <c:v>7.8609698682684863</c:v>
                  </c:pt>
                  <c:pt idx="1">
                    <c:v>4.549671466442561</c:v>
                  </c:pt>
                  <c:pt idx="2">
                    <c:v>17.896367645848855</c:v>
                  </c:pt>
                  <c:pt idx="3">
                    <c:v>21.656062874416971</c:v>
                  </c:pt>
                  <c:pt idx="4">
                    <c:v>34.254557436753537</c:v>
                  </c:pt>
                  <c:pt idx="5">
                    <c:v>24.38022875874649</c:v>
                  </c:pt>
                  <c:pt idx="6">
                    <c:v>18.899997023216567</c:v>
                  </c:pt>
                  <c:pt idx="7">
                    <c:v>55.0428170019922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#20'!$B$7:$B$1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#20'!$I$31:$I$38</c:f>
              <c:numCache>
                <c:formatCode>General</c:formatCode>
                <c:ptCount val="8"/>
                <c:pt idx="0">
                  <c:v>54.1873268061643</c:v>
                </c:pt>
                <c:pt idx="1">
                  <c:v>152.04147548413297</c:v>
                </c:pt>
                <c:pt idx="2">
                  <c:v>354.00593702439727</c:v>
                </c:pt>
                <c:pt idx="3">
                  <c:v>276.70240525503908</c:v>
                </c:pt>
                <c:pt idx="4">
                  <c:v>327.50368617405223</c:v>
                </c:pt>
                <c:pt idx="5">
                  <c:v>212.7151798076101</c:v>
                </c:pt>
                <c:pt idx="6">
                  <c:v>153.89668488491807</c:v>
                </c:pt>
                <c:pt idx="7">
                  <c:v>73.4417912044024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9E8C-492A-BA16-EE9E61E604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tradiol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4631163949168036"/>
          <c:y val="0.11745052491220637"/>
          <c:w val="0.66656959087229772"/>
          <c:h val="0.63798587062618706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L#3'!$J$7:$J$14</c:f>
                <c:numCache>
                  <c:formatCode>General</c:formatCode>
                  <c:ptCount val="8"/>
                  <c:pt idx="0">
                    <c:v>13.796521030546495</c:v>
                  </c:pt>
                  <c:pt idx="1">
                    <c:v>13.133318246062863</c:v>
                  </c:pt>
                  <c:pt idx="2">
                    <c:v>7.3519167026373964</c:v>
                  </c:pt>
                  <c:pt idx="3">
                    <c:v>20.87156822083163</c:v>
                  </c:pt>
                  <c:pt idx="4">
                    <c:v>21.167836135551312</c:v>
                  </c:pt>
                  <c:pt idx="5">
                    <c:v>25.819318476639751</c:v>
                  </c:pt>
                  <c:pt idx="6">
                    <c:v>21.894619431506669</c:v>
                  </c:pt>
                  <c:pt idx="7">
                    <c:v>3.5428633171979129</c:v>
                  </c:pt>
                </c:numCache>
              </c:numRef>
            </c:plus>
            <c:minus>
              <c:numRef>
                <c:f>'PL#3'!$J$7:$J$14</c:f>
                <c:numCache>
                  <c:formatCode>General</c:formatCode>
                  <c:ptCount val="8"/>
                  <c:pt idx="0">
                    <c:v>13.796521030546495</c:v>
                  </c:pt>
                  <c:pt idx="1">
                    <c:v>13.133318246062863</c:v>
                  </c:pt>
                  <c:pt idx="2">
                    <c:v>7.3519167026373964</c:v>
                  </c:pt>
                  <c:pt idx="3">
                    <c:v>20.87156822083163</c:v>
                  </c:pt>
                  <c:pt idx="4">
                    <c:v>21.167836135551312</c:v>
                  </c:pt>
                  <c:pt idx="5">
                    <c:v>25.819318476639751</c:v>
                  </c:pt>
                  <c:pt idx="6">
                    <c:v>21.894619431506669</c:v>
                  </c:pt>
                  <c:pt idx="7">
                    <c:v>3.54286331719791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PL#3'!$B$7:$B$1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PL#3'!$I$7:$I$14</c:f>
              <c:numCache>
                <c:formatCode>General</c:formatCode>
                <c:ptCount val="8"/>
                <c:pt idx="0">
                  <c:v>100.3406701190427</c:v>
                </c:pt>
                <c:pt idx="1">
                  <c:v>131.15115908021158</c:v>
                </c:pt>
                <c:pt idx="2">
                  <c:v>171.45455063330567</c:v>
                </c:pt>
                <c:pt idx="3">
                  <c:v>188.16918280193525</c:v>
                </c:pt>
                <c:pt idx="4">
                  <c:v>362.45550262246661</c:v>
                </c:pt>
                <c:pt idx="5">
                  <c:v>364.26338376042503</c:v>
                </c:pt>
                <c:pt idx="6">
                  <c:v>435.47304376347989</c:v>
                </c:pt>
                <c:pt idx="7">
                  <c:v>192.636336317989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295-464E-96F2-8EE711FDCF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3081248074594122"/>
              <c:y val="0.8515852457927575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E</a:t>
                </a:r>
                <a:r>
                  <a:rPr lang="en-US" altLang="ja-JP" sz="600" baseline="-25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3.0924356961207516E-2"/>
              <c:y val="0.1650789407089236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995035644322911"/>
          <c:y val="0.11536311303685756"/>
          <c:w val="0.65303327114912069"/>
          <c:h val="0.62344472438786114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7632-45DE-9C79-06158AD80EE6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7632-45DE-9C79-06158AD80EE6}"/>
              </c:ext>
            </c:extLst>
          </c:dPt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7632-45DE-9C79-06158AD80EE6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7632-45DE-9C79-06158AD80EE6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7632-45DE-9C79-06158AD80EE6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7632-45DE-9C79-06158AD80EE6}"/>
              </c:ext>
            </c:extLst>
          </c:dPt>
          <c:dPt>
            <c:idx val="6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7632-45DE-9C79-06158AD80EE6}"/>
              </c:ext>
            </c:extLst>
          </c:dPt>
          <c:dPt>
            <c:idx val="7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7632-45DE-9C79-06158AD80EE6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#17'!$J$7:$J$14</c:f>
                <c:numCache>
                  <c:formatCode>General</c:formatCode>
                  <c:ptCount val="8"/>
                  <c:pt idx="0">
                    <c:v>24.603987039440522</c:v>
                  </c:pt>
                  <c:pt idx="1">
                    <c:v>17.595139899368885</c:v>
                  </c:pt>
                  <c:pt idx="2">
                    <c:v>96.016429726600393</c:v>
                  </c:pt>
                  <c:pt idx="3">
                    <c:v>52.095928684716569</c:v>
                  </c:pt>
                  <c:pt idx="4">
                    <c:v>55.182085121383146</c:v>
                  </c:pt>
                  <c:pt idx="5">
                    <c:v>34.602276984505387</c:v>
                  </c:pt>
                  <c:pt idx="6">
                    <c:v>21.019948181159062</c:v>
                  </c:pt>
                  <c:pt idx="7">
                    <c:v>16.681556690613675</c:v>
                  </c:pt>
                </c:numCache>
              </c:numRef>
            </c:plus>
            <c:minus>
              <c:numRef>
                <c:f>'#17'!$J$7:$J$14</c:f>
                <c:numCache>
                  <c:formatCode>General</c:formatCode>
                  <c:ptCount val="8"/>
                  <c:pt idx="0">
                    <c:v>24.603987039440522</c:v>
                  </c:pt>
                  <c:pt idx="1">
                    <c:v>17.595139899368885</c:v>
                  </c:pt>
                  <c:pt idx="2">
                    <c:v>96.016429726600393</c:v>
                  </c:pt>
                  <c:pt idx="3">
                    <c:v>52.095928684716569</c:v>
                  </c:pt>
                  <c:pt idx="4">
                    <c:v>55.182085121383146</c:v>
                  </c:pt>
                  <c:pt idx="5">
                    <c:v>34.602276984505387</c:v>
                  </c:pt>
                  <c:pt idx="6">
                    <c:v>21.019948181159062</c:v>
                  </c:pt>
                  <c:pt idx="7">
                    <c:v>16.6815566906136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#17'!$B$7:$B$1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#17'!$I$7:$I$14</c:f>
              <c:numCache>
                <c:formatCode>General</c:formatCode>
                <c:ptCount val="8"/>
                <c:pt idx="0">
                  <c:v>112.61102149989722</c:v>
                </c:pt>
                <c:pt idx="1">
                  <c:v>256.31315876096909</c:v>
                </c:pt>
                <c:pt idx="2">
                  <c:v>508.79768629493213</c:v>
                </c:pt>
                <c:pt idx="3">
                  <c:v>587.16632146795564</c:v>
                </c:pt>
                <c:pt idx="4">
                  <c:v>809.73864815092259</c:v>
                </c:pt>
                <c:pt idx="5">
                  <c:v>344.28752857544004</c:v>
                </c:pt>
                <c:pt idx="6">
                  <c:v>269.81789058827377</c:v>
                </c:pt>
                <c:pt idx="7">
                  <c:v>116.932008875656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7632-45DE-9C79-06158AD80E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E</a:t>
                </a:r>
                <a:r>
                  <a:rPr lang="en-US" altLang="ja-JP" sz="600" baseline="-25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ja-JP" sz="6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203977713344278"/>
          <c:y val="0.12585066876748097"/>
          <c:w val="0.6372121125295479"/>
          <c:h val="0.62344472438786114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6744-4BDA-9AED-72E5E35972B6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6744-4BDA-9AED-72E5E35972B6}"/>
              </c:ext>
            </c:extLst>
          </c:dPt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6744-4BDA-9AED-72E5E35972B6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6744-4BDA-9AED-72E5E35972B6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6744-4BDA-9AED-72E5E35972B6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6744-4BDA-9AED-72E5E35972B6}"/>
              </c:ext>
            </c:extLst>
          </c:dPt>
          <c:dPt>
            <c:idx val="6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6744-4BDA-9AED-72E5E35972B6}"/>
              </c:ext>
            </c:extLst>
          </c:dPt>
          <c:dPt>
            <c:idx val="7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6744-4BDA-9AED-72E5E35972B6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#20'!$J$7:$J$14</c:f>
                <c:numCache>
                  <c:formatCode>General</c:formatCode>
                  <c:ptCount val="8"/>
                  <c:pt idx="0">
                    <c:v>13.690980312999061</c:v>
                  </c:pt>
                  <c:pt idx="1">
                    <c:v>16.124926463995635</c:v>
                  </c:pt>
                  <c:pt idx="2">
                    <c:v>64.963751217316982</c:v>
                  </c:pt>
                  <c:pt idx="3">
                    <c:v>86.705385844825727</c:v>
                  </c:pt>
                  <c:pt idx="4">
                    <c:v>156.89806810930338</c:v>
                  </c:pt>
                  <c:pt idx="5">
                    <c:v>13.904531529018445</c:v>
                  </c:pt>
                  <c:pt idx="6">
                    <c:v>13.982284908532893</c:v>
                  </c:pt>
                  <c:pt idx="7">
                    <c:v>7.260139441348735</c:v>
                  </c:pt>
                </c:numCache>
              </c:numRef>
            </c:plus>
            <c:minus>
              <c:numRef>
                <c:f>'#20'!$J$7:$J$14</c:f>
                <c:numCache>
                  <c:formatCode>General</c:formatCode>
                  <c:ptCount val="8"/>
                  <c:pt idx="0">
                    <c:v>13.690980312999061</c:v>
                  </c:pt>
                  <c:pt idx="1">
                    <c:v>16.124926463995635</c:v>
                  </c:pt>
                  <c:pt idx="2">
                    <c:v>64.963751217316982</c:v>
                  </c:pt>
                  <c:pt idx="3">
                    <c:v>86.705385844825727</c:v>
                  </c:pt>
                  <c:pt idx="4">
                    <c:v>156.89806810930338</c:v>
                  </c:pt>
                  <c:pt idx="5">
                    <c:v>13.904531529018445</c:v>
                  </c:pt>
                  <c:pt idx="6">
                    <c:v>13.982284908532893</c:v>
                  </c:pt>
                  <c:pt idx="7">
                    <c:v>7.2601394413487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#20'!$B$7:$B$1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#20'!$I$7:$I$14</c:f>
              <c:numCache>
                <c:formatCode>General</c:formatCode>
                <c:ptCount val="8"/>
                <c:pt idx="0">
                  <c:v>165.3809929066953</c:v>
                </c:pt>
                <c:pt idx="1">
                  <c:v>169.29012370985788</c:v>
                </c:pt>
                <c:pt idx="2">
                  <c:v>597.16369866356069</c:v>
                </c:pt>
                <c:pt idx="3">
                  <c:v>807.7877570747487</c:v>
                </c:pt>
                <c:pt idx="4">
                  <c:v>768.4047232241852</c:v>
                </c:pt>
                <c:pt idx="5">
                  <c:v>549.65547769119996</c:v>
                </c:pt>
                <c:pt idx="6">
                  <c:v>367.65751455731288</c:v>
                </c:pt>
                <c:pt idx="7">
                  <c:v>173.459885213858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6744-4BDA-9AED-72E5E35972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E</a:t>
                </a:r>
                <a:r>
                  <a:rPr lang="en-US" altLang="ja-JP" sz="600" baseline="-25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3.1642317239145533E-2"/>
              <c:y val="0.1815189449023459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782617415970388"/>
          <c:y val="0.11536301777102465"/>
          <c:w val="0.65515750763339287"/>
          <c:h val="0.61295748827376628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DDE7-46C5-921F-A77501543C42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#17'!$O$7:$O$14</c:f>
                <c:numCache>
                  <c:formatCode>General</c:formatCode>
                  <c:ptCount val="8"/>
                  <c:pt idx="0">
                    <c:v>0.54365021434333616</c:v>
                  </c:pt>
                  <c:pt idx="1">
                    <c:v>0.43204937989385744</c:v>
                  </c:pt>
                  <c:pt idx="2">
                    <c:v>0.89566858950296002</c:v>
                  </c:pt>
                  <c:pt idx="3">
                    <c:v>0.29439202887759525</c:v>
                  </c:pt>
                  <c:pt idx="4">
                    <c:v>0.50920417210475477</c:v>
                  </c:pt>
                  <c:pt idx="5">
                    <c:v>0.22226110770892868</c:v>
                  </c:pt>
                  <c:pt idx="6">
                    <c:v>0.2152832759154519</c:v>
                  </c:pt>
                  <c:pt idx="7">
                    <c:v>0.26386023236217721</c:v>
                  </c:pt>
                </c:numCache>
              </c:numRef>
            </c:plus>
            <c:minus>
              <c:numRef>
                <c:f>'#17'!$O$7:$O$14</c:f>
                <c:numCache>
                  <c:formatCode>General</c:formatCode>
                  <c:ptCount val="8"/>
                  <c:pt idx="0">
                    <c:v>0.54365021434333616</c:v>
                  </c:pt>
                  <c:pt idx="1">
                    <c:v>0.43204937989385744</c:v>
                  </c:pt>
                  <c:pt idx="2">
                    <c:v>0.89566858950296002</c:v>
                  </c:pt>
                  <c:pt idx="3">
                    <c:v>0.29439202887759525</c:v>
                  </c:pt>
                  <c:pt idx="4">
                    <c:v>0.50920417210475477</c:v>
                  </c:pt>
                  <c:pt idx="5">
                    <c:v>0.22226110770892868</c:v>
                  </c:pt>
                  <c:pt idx="6">
                    <c:v>0.2152832759154519</c:v>
                  </c:pt>
                  <c:pt idx="7">
                    <c:v>0.263860232362177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#17'!$B$7:$B$1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#17'!$N$7:$N$14</c:f>
              <c:numCache>
                <c:formatCode>General</c:formatCode>
                <c:ptCount val="8"/>
                <c:pt idx="0">
                  <c:v>14.766666666666666</c:v>
                </c:pt>
                <c:pt idx="1">
                  <c:v>11.6</c:v>
                </c:pt>
                <c:pt idx="2">
                  <c:v>11.266666666666666</c:v>
                </c:pt>
                <c:pt idx="3">
                  <c:v>10.5</c:v>
                </c:pt>
                <c:pt idx="4">
                  <c:v>7.3266666666666671</c:v>
                </c:pt>
                <c:pt idx="5">
                  <c:v>3.23</c:v>
                </c:pt>
                <c:pt idx="6">
                  <c:v>0.99366666666666681</c:v>
                </c:pt>
                <c:pt idx="7">
                  <c:v>8.88333333333333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DE7-46C5-921F-A77501543C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ng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5.5374020677120252E-2"/>
              <c:y val="0.176354297416925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364749337411121"/>
          <c:y val="0.11536301777102465"/>
          <c:w val="0.63933613421823854"/>
          <c:h val="0.63393258241395256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B07C-428B-8955-F50250D61A92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B07C-428B-8955-F50250D61A92}"/>
              </c:ext>
            </c:extLst>
          </c:dPt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B07C-428B-8955-F50250D61A92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B07C-428B-8955-F50250D61A92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B07C-428B-8955-F50250D61A92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B07C-428B-8955-F50250D61A92}"/>
              </c:ext>
            </c:extLst>
          </c:dPt>
          <c:dPt>
            <c:idx val="6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B07C-428B-8955-F50250D61A92}"/>
              </c:ext>
            </c:extLst>
          </c:dPt>
          <c:dPt>
            <c:idx val="7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B07C-428B-8955-F50250D61A92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#20'!$O$7:$O$14</c:f>
                <c:numCache>
                  <c:formatCode>General</c:formatCode>
                  <c:ptCount val="8"/>
                  <c:pt idx="0">
                    <c:v>0.51545018080207206</c:v>
                  </c:pt>
                  <c:pt idx="1">
                    <c:v>0.22125902367034755</c:v>
                  </c:pt>
                  <c:pt idx="2">
                    <c:v>0.44639295095987652</c:v>
                  </c:pt>
                  <c:pt idx="3">
                    <c:v>0.33146141052416817</c:v>
                  </c:pt>
                  <c:pt idx="4">
                    <c:v>2.3570226039551501E-2</c:v>
                  </c:pt>
                  <c:pt idx="5">
                    <c:v>8.9938250421547031E-2</c:v>
                  </c:pt>
                  <c:pt idx="6">
                    <c:v>7.3484692283495412E-2</c:v>
                  </c:pt>
                  <c:pt idx="7">
                    <c:v>0.48110982807116576</c:v>
                  </c:pt>
                </c:numCache>
              </c:numRef>
            </c:plus>
            <c:minus>
              <c:numRef>
                <c:f>'#20'!$O$7:$O$14</c:f>
                <c:numCache>
                  <c:formatCode>General</c:formatCode>
                  <c:ptCount val="8"/>
                  <c:pt idx="0">
                    <c:v>0.51545018080207206</c:v>
                  </c:pt>
                  <c:pt idx="1">
                    <c:v>0.22125902367034755</c:v>
                  </c:pt>
                  <c:pt idx="2">
                    <c:v>0.44639295095987652</c:v>
                  </c:pt>
                  <c:pt idx="3">
                    <c:v>0.33146141052416817</c:v>
                  </c:pt>
                  <c:pt idx="4">
                    <c:v>2.3570226039551501E-2</c:v>
                  </c:pt>
                  <c:pt idx="5">
                    <c:v>8.9938250421547031E-2</c:v>
                  </c:pt>
                  <c:pt idx="6">
                    <c:v>7.3484692283495412E-2</c:v>
                  </c:pt>
                  <c:pt idx="7">
                    <c:v>0.481109828071165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#20'!$B$7:$B$1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#20'!$N$7:$N$14</c:f>
              <c:numCache>
                <c:formatCode>General</c:formatCode>
                <c:ptCount val="8"/>
                <c:pt idx="0">
                  <c:v>8.5166666666666675</c:v>
                </c:pt>
                <c:pt idx="1">
                  <c:v>8.8166666666666682</c:v>
                </c:pt>
                <c:pt idx="2">
                  <c:v>8.19</c:v>
                </c:pt>
                <c:pt idx="3">
                  <c:v>3.0199999999999996</c:v>
                </c:pt>
                <c:pt idx="4">
                  <c:v>2.0133333333333332</c:v>
                </c:pt>
                <c:pt idx="5">
                  <c:v>2.5866666666666669</c:v>
                </c:pt>
                <c:pt idx="6">
                  <c:v>2.5700000000000003</c:v>
                </c:pt>
                <c:pt idx="7">
                  <c:v>6.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B07C-428B-8955-F50250D61A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 post-administration</a:t>
                </a:r>
                <a:endParaRPr lang="ja-JP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ng/mL)</a:t>
                </a:r>
                <a:endParaRPr lang="ja-JP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600"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392959584414287"/>
          <c:y val="0.11536301777102465"/>
          <c:w val="0.65905403174820687"/>
          <c:h val="0.63393258241395256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59FA-4F7B-A2DC-447AD38517F5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59FA-4F7B-A2DC-447AD38517F5}"/>
              </c:ext>
            </c:extLst>
          </c:dPt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59FA-4F7B-A2DC-447AD38517F5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59FA-4F7B-A2DC-447AD38517F5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59FA-4F7B-A2DC-447AD38517F5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59FA-4F7B-A2DC-447AD38517F5}"/>
              </c:ext>
            </c:extLst>
          </c:dPt>
          <c:dPt>
            <c:idx val="6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59FA-4F7B-A2DC-447AD38517F5}"/>
              </c:ext>
            </c:extLst>
          </c:dPt>
          <c:dPt>
            <c:idx val="7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59FA-4F7B-A2DC-447AD38517F5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#17'!$O$19:$O$26</c:f>
                <c:numCache>
                  <c:formatCode>General</c:formatCode>
                  <c:ptCount val="8"/>
                  <c:pt idx="0">
                    <c:v>79.190955646603499</c:v>
                  </c:pt>
                  <c:pt idx="1">
                    <c:v>227.84525140590975</c:v>
                  </c:pt>
                  <c:pt idx="2">
                    <c:v>22.778262595924392</c:v>
                  </c:pt>
                  <c:pt idx="3">
                    <c:v>6.8050509345795582</c:v>
                  </c:pt>
                  <c:pt idx="4">
                    <c:v>5.6214989104330533</c:v>
                  </c:pt>
                  <c:pt idx="5">
                    <c:v>26.397242208651658</c:v>
                  </c:pt>
                  <c:pt idx="6">
                    <c:v>20.435811790960386</c:v>
                  </c:pt>
                  <c:pt idx="7">
                    <c:v>97.710889363582183</c:v>
                  </c:pt>
                </c:numCache>
              </c:numRef>
            </c:plus>
            <c:minus>
              <c:numRef>
                <c:f>'#17'!$O$19:$O$26</c:f>
                <c:numCache>
                  <c:formatCode>General</c:formatCode>
                  <c:ptCount val="8"/>
                  <c:pt idx="0">
                    <c:v>79.190955646603499</c:v>
                  </c:pt>
                  <c:pt idx="1">
                    <c:v>227.84525140590975</c:v>
                  </c:pt>
                  <c:pt idx="2">
                    <c:v>22.778262595924392</c:v>
                  </c:pt>
                  <c:pt idx="3">
                    <c:v>6.8050509345795582</c:v>
                  </c:pt>
                  <c:pt idx="4">
                    <c:v>5.6214989104330533</c:v>
                  </c:pt>
                  <c:pt idx="5">
                    <c:v>26.397242208651658</c:v>
                  </c:pt>
                  <c:pt idx="6">
                    <c:v>20.435811790960386</c:v>
                  </c:pt>
                  <c:pt idx="7">
                    <c:v>97.7108893635821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#17'!$B$19:$B$26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#17'!$N$19:$N$26</c:f>
              <c:numCache>
                <c:formatCode>General</c:formatCode>
                <c:ptCount val="8"/>
                <c:pt idx="0">
                  <c:v>582.87766666666664</c:v>
                </c:pt>
                <c:pt idx="1">
                  <c:v>249.61733333333333</c:v>
                </c:pt>
                <c:pt idx="2">
                  <c:v>535.73966666666672</c:v>
                </c:pt>
                <c:pt idx="3">
                  <c:v>26.439666666666668</c:v>
                </c:pt>
                <c:pt idx="4">
                  <c:v>3.9750000000000001</c:v>
                </c:pt>
                <c:pt idx="5">
                  <c:v>91.180666666666681</c:v>
                </c:pt>
                <c:pt idx="6">
                  <c:v>29.200333333333333</c:v>
                </c:pt>
                <c:pt idx="7">
                  <c:v>436.9076666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59FA-4F7B-A2DC-447AD38517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  <c:max val="8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5.4596700603259531E-2"/>
              <c:y val="0.176354297416925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766133377350205"/>
          <c:y val="0.11536301777102465"/>
          <c:w val="0.63532229381884775"/>
          <c:h val="0.60246994120367314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0CC7-4C8E-B2ED-82FC2C3F29F5}"/>
              </c:ext>
            </c:extLst>
          </c:dPt>
          <c:dPt>
            <c:idx val="1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0CC7-4C8E-B2ED-82FC2C3F29F5}"/>
              </c:ext>
            </c:extLst>
          </c:dPt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0CC7-4C8E-B2ED-82FC2C3F29F5}"/>
              </c:ext>
            </c:extLst>
          </c:dPt>
          <c:dPt>
            <c:idx val="3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0CC7-4C8E-B2ED-82FC2C3F29F5}"/>
              </c:ext>
            </c:extLst>
          </c:dPt>
          <c:dPt>
            <c:idx val="4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0CC7-4C8E-B2ED-82FC2C3F29F5}"/>
              </c:ext>
            </c:extLst>
          </c:dPt>
          <c:dPt>
            <c:idx val="5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0CC7-4C8E-B2ED-82FC2C3F29F5}"/>
              </c:ext>
            </c:extLst>
          </c:dPt>
          <c:dPt>
            <c:idx val="6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0CC7-4C8E-B2ED-82FC2C3F29F5}"/>
              </c:ext>
            </c:extLst>
          </c:dPt>
          <c:dPt>
            <c:idx val="7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0CC7-4C8E-B2ED-82FC2C3F29F5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#20'!$O$19:$O$26</c:f>
                <c:numCache>
                  <c:formatCode>General</c:formatCode>
                  <c:ptCount val="8"/>
                  <c:pt idx="0">
                    <c:v>13.480267710826704</c:v>
                  </c:pt>
                  <c:pt idx="1">
                    <c:v>7.1607961537496356</c:v>
                  </c:pt>
                  <c:pt idx="2">
                    <c:v>10.880039225827989</c:v>
                  </c:pt>
                  <c:pt idx="3">
                    <c:v>29.526312811155812</c:v>
                  </c:pt>
                  <c:pt idx="4">
                    <c:v>0</c:v>
                  </c:pt>
                  <c:pt idx="5">
                    <c:v>18.428644014745686</c:v>
                  </c:pt>
                  <c:pt idx="6">
                    <c:v>11.973672406112046</c:v>
                  </c:pt>
                  <c:pt idx="7">
                    <c:v>27.461311371131174</c:v>
                  </c:pt>
                </c:numCache>
              </c:numRef>
            </c:plus>
            <c:minus>
              <c:numRef>
                <c:f>'#20'!$O$19:$O$26</c:f>
                <c:numCache>
                  <c:formatCode>General</c:formatCode>
                  <c:ptCount val="8"/>
                  <c:pt idx="0">
                    <c:v>13.480267710826704</c:v>
                  </c:pt>
                  <c:pt idx="1">
                    <c:v>7.1607961537496356</c:v>
                  </c:pt>
                  <c:pt idx="2">
                    <c:v>10.880039225827989</c:v>
                  </c:pt>
                  <c:pt idx="3">
                    <c:v>29.526312811155812</c:v>
                  </c:pt>
                  <c:pt idx="4">
                    <c:v>0</c:v>
                  </c:pt>
                  <c:pt idx="5">
                    <c:v>18.428644014745686</c:v>
                  </c:pt>
                  <c:pt idx="6">
                    <c:v>11.973672406112046</c:v>
                  </c:pt>
                  <c:pt idx="7">
                    <c:v>27.4613113711311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#20'!$B$19:$B$26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#20'!$N$19:$N$26</c:f>
              <c:numCache>
                <c:formatCode>General</c:formatCode>
                <c:ptCount val="8"/>
                <c:pt idx="0">
                  <c:v>84.529333333333327</c:v>
                </c:pt>
                <c:pt idx="1">
                  <c:v>16.672666666666668</c:v>
                </c:pt>
                <c:pt idx="2">
                  <c:v>58.386666666666663</c:v>
                </c:pt>
                <c:pt idx="3">
                  <c:v>160.60266666666666</c:v>
                </c:pt>
                <c:pt idx="4">
                  <c:v>0</c:v>
                </c:pt>
                <c:pt idx="5">
                  <c:v>28.917333333333335</c:v>
                </c:pt>
                <c:pt idx="6">
                  <c:v>30.799666666666667</c:v>
                </c:pt>
                <c:pt idx="7">
                  <c:v>124.203333333333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0CC7-4C8E-B2ED-82FC2C3F29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γ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766116082384584"/>
          <c:y val="0.11536311303685756"/>
          <c:w val="0.6353225209692509"/>
          <c:h val="0.62344472438786114"/>
        </c:manualLayout>
      </c:layout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L#1'!$J$31:$J$38</c:f>
                <c:numCache>
                  <c:formatCode>General</c:formatCode>
                  <c:ptCount val="8"/>
                  <c:pt idx="0">
                    <c:v>12.733162993893048</c:v>
                  </c:pt>
                  <c:pt idx="1">
                    <c:v>1.6704072891693045</c:v>
                  </c:pt>
                  <c:pt idx="2">
                    <c:v>2.0312481059884959</c:v>
                  </c:pt>
                  <c:pt idx="3">
                    <c:v>8.0635899014591246</c:v>
                  </c:pt>
                  <c:pt idx="4">
                    <c:v>2.1638217068014569</c:v>
                  </c:pt>
                  <c:pt idx="5">
                    <c:v>0</c:v>
                  </c:pt>
                  <c:pt idx="6">
                    <c:v>20.182671578855931</c:v>
                  </c:pt>
                  <c:pt idx="7">
                    <c:v>6.6345639774145582</c:v>
                  </c:pt>
                </c:numCache>
              </c:numRef>
            </c:plus>
            <c:minus>
              <c:numRef>
                <c:f>'PL#1'!$J$31:$J$38</c:f>
                <c:numCache>
                  <c:formatCode>General</c:formatCode>
                  <c:ptCount val="8"/>
                  <c:pt idx="0">
                    <c:v>12.733162993893048</c:v>
                  </c:pt>
                  <c:pt idx="1">
                    <c:v>1.6704072891693045</c:v>
                  </c:pt>
                  <c:pt idx="2">
                    <c:v>2.0312481059884959</c:v>
                  </c:pt>
                  <c:pt idx="3">
                    <c:v>8.0635899014591246</c:v>
                  </c:pt>
                  <c:pt idx="4">
                    <c:v>2.1638217068014569</c:v>
                  </c:pt>
                  <c:pt idx="5">
                    <c:v>0</c:v>
                  </c:pt>
                  <c:pt idx="6">
                    <c:v>20.182671578855931</c:v>
                  </c:pt>
                  <c:pt idx="7">
                    <c:v>6.63456397741455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L#1'!$B$7:$B$1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6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  <c:pt idx="6">
                  <c:v>96</c:v>
                </c:pt>
                <c:pt idx="7">
                  <c:v>168</c:v>
                </c:pt>
              </c:numCache>
            </c:numRef>
          </c:cat>
          <c:val>
            <c:numRef>
              <c:f>'PL#1'!$I$31:$I$38</c:f>
              <c:numCache>
                <c:formatCode>General</c:formatCode>
                <c:ptCount val="8"/>
                <c:pt idx="0">
                  <c:v>126.23332509709073</c:v>
                </c:pt>
                <c:pt idx="1">
                  <c:v>200.98180083643908</c:v>
                </c:pt>
                <c:pt idx="2">
                  <c:v>248.89459623373403</c:v>
                </c:pt>
                <c:pt idx="3">
                  <c:v>246.98887747567667</c:v>
                </c:pt>
                <c:pt idx="4">
                  <c:v>265.66760520853632</c:v>
                </c:pt>
                <c:pt idx="5">
                  <c:v>250.92584433972252</c:v>
                </c:pt>
                <c:pt idx="6">
                  <c:v>247.64875533648183</c:v>
                </c:pt>
                <c:pt idx="7">
                  <c:v>199.407428089875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636-4501-B492-46E48D8240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6917800"/>
        <c:axId val="666911240"/>
      </c:lineChart>
      <c:dateAx>
        <c:axId val="666917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urs</a:t>
                </a:r>
                <a:r>
                  <a:rPr lang="en-US" altLang="ja-JP" sz="6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-administration</a:t>
                </a:r>
                <a:endParaRPr lang="ja-JP" altLang="en-US" sz="6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1240"/>
        <c:crosses val="autoZero"/>
        <c:auto val="0"/>
        <c:lblOffset val="100"/>
        <c:baseTimeUnit val="days"/>
        <c:majorUnit val="24"/>
        <c:majorTimeUnit val="days"/>
      </c:dateAx>
      <c:valAx>
        <c:axId val="6669112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tradiol (</a:t>
                </a:r>
                <a:r>
                  <a:rPr lang="en-US" altLang="ja-JP" sz="6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en-US" altLang="ja-JP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mL)</a:t>
                </a:r>
                <a:endParaRPr lang="ja-JP" altLang="en-US" sz="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6917800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7506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7426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33355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1811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6025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6359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05109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949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9515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4625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3457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91022F-DE56-4A38-804B-03CA95AF64B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D21795-5A08-4B44-81B2-900484F4B7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7419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18" Type="http://schemas.openxmlformats.org/officeDocument/2006/relationships/chart" Target="../charts/chart17.xml"/><Relationship Id="rId3" Type="http://schemas.openxmlformats.org/officeDocument/2006/relationships/chart" Target="../charts/chart2.xml"/><Relationship Id="rId21" Type="http://schemas.openxmlformats.org/officeDocument/2006/relationships/chart" Target="../charts/chart20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20" Type="http://schemas.openxmlformats.org/officeDocument/2006/relationships/chart" Target="../charts/chart19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19" Type="http://schemas.openxmlformats.org/officeDocument/2006/relationships/chart" Target="../charts/chart18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EEB7320F-4E6D-48E5-8C0C-9511D6D27A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9174552"/>
              </p:ext>
            </p:extLst>
          </p:nvPr>
        </p:nvGraphicFramePr>
        <p:xfrm>
          <a:off x="1034348" y="760431"/>
          <a:ext cx="8064175" cy="4896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12835">
                  <a:extLst>
                    <a:ext uri="{9D8B030D-6E8A-4147-A177-3AD203B41FA5}">
                      <a16:colId xmlns:a16="http://schemas.microsoft.com/office/drawing/2014/main" val="3619079823"/>
                    </a:ext>
                  </a:extLst>
                </a:gridCol>
                <a:gridCol w="1612835">
                  <a:extLst>
                    <a:ext uri="{9D8B030D-6E8A-4147-A177-3AD203B41FA5}">
                      <a16:colId xmlns:a16="http://schemas.microsoft.com/office/drawing/2014/main" val="2155430796"/>
                    </a:ext>
                  </a:extLst>
                </a:gridCol>
                <a:gridCol w="1612835">
                  <a:extLst>
                    <a:ext uri="{9D8B030D-6E8A-4147-A177-3AD203B41FA5}">
                      <a16:colId xmlns:a16="http://schemas.microsoft.com/office/drawing/2014/main" val="2874739532"/>
                    </a:ext>
                  </a:extLst>
                </a:gridCol>
                <a:gridCol w="1612835">
                  <a:extLst>
                    <a:ext uri="{9D8B030D-6E8A-4147-A177-3AD203B41FA5}">
                      <a16:colId xmlns:a16="http://schemas.microsoft.com/office/drawing/2014/main" val="4000538848"/>
                    </a:ext>
                  </a:extLst>
                </a:gridCol>
                <a:gridCol w="1612835">
                  <a:extLst>
                    <a:ext uri="{9D8B030D-6E8A-4147-A177-3AD203B41FA5}">
                      <a16:colId xmlns:a16="http://schemas.microsoft.com/office/drawing/2014/main" val="2025257637"/>
                    </a:ext>
                  </a:extLst>
                </a:gridCol>
              </a:tblGrid>
              <a:tr h="1224000"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2631903"/>
                  </a:ext>
                </a:extLst>
              </a:tr>
              <a:tr h="1224000"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2098076"/>
                  </a:ext>
                </a:extLst>
              </a:tr>
              <a:tr h="1224000"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8735713"/>
                  </a:ext>
                </a:extLst>
              </a:tr>
              <a:tr h="1224000"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6389948"/>
                  </a:ext>
                </a:extLst>
              </a:tr>
            </a:tbl>
          </a:graphicData>
        </a:graphic>
      </p:graphicFrame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2B2D419-117B-4197-875F-48323B0501C5}"/>
              </a:ext>
            </a:extLst>
          </p:cNvPr>
          <p:cNvSpPr txBox="1"/>
          <p:nvPr/>
        </p:nvSpPr>
        <p:spPr>
          <a:xfrm>
            <a:off x="1028069" y="503454"/>
            <a:ext cx="16054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imal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#6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E11D11A-0430-4FDE-ABEE-2327C1EF2331}"/>
              </a:ext>
            </a:extLst>
          </p:cNvPr>
          <p:cNvSpPr txBox="1"/>
          <p:nvPr/>
        </p:nvSpPr>
        <p:spPr>
          <a:xfrm>
            <a:off x="2633514" y="501198"/>
            <a:ext cx="16054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imal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#7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0AF336E-F4C2-402B-8F6B-FB6919BF1C3E}"/>
              </a:ext>
            </a:extLst>
          </p:cNvPr>
          <p:cNvSpPr txBox="1"/>
          <p:nvPr/>
        </p:nvSpPr>
        <p:spPr>
          <a:xfrm>
            <a:off x="4268429" y="503849"/>
            <a:ext cx="16054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imal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#8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C62D14F-DB67-4342-8167-8D35A5D4EBE3}"/>
              </a:ext>
            </a:extLst>
          </p:cNvPr>
          <p:cNvSpPr txBox="1"/>
          <p:nvPr/>
        </p:nvSpPr>
        <p:spPr>
          <a:xfrm>
            <a:off x="5873874" y="501970"/>
            <a:ext cx="16054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imal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#9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58405EC4-F9F3-4AEF-9058-A71A143BA2B7}"/>
              </a:ext>
            </a:extLst>
          </p:cNvPr>
          <p:cNvSpPr txBox="1"/>
          <p:nvPr/>
        </p:nvSpPr>
        <p:spPr>
          <a:xfrm>
            <a:off x="7508789" y="505083"/>
            <a:ext cx="16054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imal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#10</a:t>
            </a:r>
          </a:p>
        </p:txBody>
      </p:sp>
      <p:graphicFrame>
        <p:nvGraphicFramePr>
          <p:cNvPr id="28" name="グラフ 27">
            <a:extLst>
              <a:ext uri="{FF2B5EF4-FFF2-40B4-BE49-F238E27FC236}">
                <a16:creationId xmlns:a16="http://schemas.microsoft.com/office/drawing/2014/main" id="{89D90997-1294-41F5-9F63-7E5FA8E45FB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9966046"/>
              </p:ext>
            </p:extLst>
          </p:nvPr>
        </p:nvGraphicFramePr>
        <p:xfrm>
          <a:off x="998932" y="752536"/>
          <a:ext cx="1634582" cy="12216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9" name="グラフ 28">
            <a:extLst>
              <a:ext uri="{FF2B5EF4-FFF2-40B4-BE49-F238E27FC236}">
                <a16:creationId xmlns:a16="http://schemas.microsoft.com/office/drawing/2014/main" id="{C3FDBCDA-F007-4832-876C-FC6C973E33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5349891"/>
              </p:ext>
            </p:extLst>
          </p:nvPr>
        </p:nvGraphicFramePr>
        <p:xfrm>
          <a:off x="2633514" y="763206"/>
          <a:ext cx="1605445" cy="12109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0" name="グラフ 29">
            <a:extLst>
              <a:ext uri="{FF2B5EF4-FFF2-40B4-BE49-F238E27FC236}">
                <a16:creationId xmlns:a16="http://schemas.microsoft.com/office/drawing/2014/main" id="{36364805-0C32-4061-8ED5-8440657D6BC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9481054"/>
              </p:ext>
            </p:extLst>
          </p:nvPr>
        </p:nvGraphicFramePr>
        <p:xfrm>
          <a:off x="1028069" y="1993602"/>
          <a:ext cx="1605445" cy="12109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1" name="グラフ 30">
            <a:extLst>
              <a:ext uri="{FF2B5EF4-FFF2-40B4-BE49-F238E27FC236}">
                <a16:creationId xmlns:a16="http://schemas.microsoft.com/office/drawing/2014/main" id="{E17D7C43-FE12-4072-B07F-E5350C93098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5762570"/>
              </p:ext>
            </p:extLst>
          </p:nvPr>
        </p:nvGraphicFramePr>
        <p:xfrm>
          <a:off x="2671489" y="2004242"/>
          <a:ext cx="1605445" cy="12109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2" name="グラフ 31">
            <a:extLst>
              <a:ext uri="{FF2B5EF4-FFF2-40B4-BE49-F238E27FC236}">
                <a16:creationId xmlns:a16="http://schemas.microsoft.com/office/drawing/2014/main" id="{95D1890E-7118-43C1-BE3A-F1140E6D1A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07348059"/>
              </p:ext>
            </p:extLst>
          </p:nvPr>
        </p:nvGraphicFramePr>
        <p:xfrm>
          <a:off x="1018644" y="3250332"/>
          <a:ext cx="1605446" cy="1210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3" name="グラフ 32">
            <a:extLst>
              <a:ext uri="{FF2B5EF4-FFF2-40B4-BE49-F238E27FC236}">
                <a16:creationId xmlns:a16="http://schemas.microsoft.com/office/drawing/2014/main" id="{4149C239-CF2C-485B-BF44-3785E054F06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7504491"/>
              </p:ext>
            </p:extLst>
          </p:nvPr>
        </p:nvGraphicFramePr>
        <p:xfrm>
          <a:off x="2626717" y="3221826"/>
          <a:ext cx="1605445" cy="1210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4" name="グラフ 33">
            <a:extLst>
              <a:ext uri="{FF2B5EF4-FFF2-40B4-BE49-F238E27FC236}">
                <a16:creationId xmlns:a16="http://schemas.microsoft.com/office/drawing/2014/main" id="{062DDB20-E2D7-4D16-AD4F-919A2FFAE43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2736795"/>
              </p:ext>
            </p:extLst>
          </p:nvPr>
        </p:nvGraphicFramePr>
        <p:xfrm>
          <a:off x="1016017" y="4415961"/>
          <a:ext cx="1605445" cy="1210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5" name="グラフ 34">
            <a:extLst>
              <a:ext uri="{FF2B5EF4-FFF2-40B4-BE49-F238E27FC236}">
                <a16:creationId xmlns:a16="http://schemas.microsoft.com/office/drawing/2014/main" id="{005F1329-1588-4275-BDAF-79CBDDFAAC7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34327715"/>
              </p:ext>
            </p:extLst>
          </p:nvPr>
        </p:nvGraphicFramePr>
        <p:xfrm>
          <a:off x="2626716" y="4456141"/>
          <a:ext cx="1605445" cy="1210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6" name="グラフ 35">
            <a:extLst>
              <a:ext uri="{FF2B5EF4-FFF2-40B4-BE49-F238E27FC236}">
                <a16:creationId xmlns:a16="http://schemas.microsoft.com/office/drawing/2014/main" id="{852803FF-B353-469B-BFA8-CBF8E946285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5706986"/>
              </p:ext>
            </p:extLst>
          </p:nvPr>
        </p:nvGraphicFramePr>
        <p:xfrm>
          <a:off x="4263712" y="775114"/>
          <a:ext cx="1605446" cy="12109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37" name="グラフ 36">
            <a:extLst>
              <a:ext uri="{FF2B5EF4-FFF2-40B4-BE49-F238E27FC236}">
                <a16:creationId xmlns:a16="http://schemas.microsoft.com/office/drawing/2014/main" id="{768778D3-03C8-42C2-B2D6-BE80D1D759D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5667792"/>
              </p:ext>
            </p:extLst>
          </p:nvPr>
        </p:nvGraphicFramePr>
        <p:xfrm>
          <a:off x="4238347" y="2013218"/>
          <a:ext cx="1605445" cy="12081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38" name="グラフ 37">
            <a:extLst>
              <a:ext uri="{FF2B5EF4-FFF2-40B4-BE49-F238E27FC236}">
                <a16:creationId xmlns:a16="http://schemas.microsoft.com/office/drawing/2014/main" id="{773C2F7C-5F1B-4EB8-85D4-F6B78F9E523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0122087"/>
              </p:ext>
            </p:extLst>
          </p:nvPr>
        </p:nvGraphicFramePr>
        <p:xfrm>
          <a:off x="4248977" y="3233655"/>
          <a:ext cx="1605445" cy="12081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39" name="グラフ 38">
            <a:extLst>
              <a:ext uri="{FF2B5EF4-FFF2-40B4-BE49-F238E27FC236}">
                <a16:creationId xmlns:a16="http://schemas.microsoft.com/office/drawing/2014/main" id="{00A8CE87-EB03-4E6E-8B74-FB97B57C765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7079140"/>
              </p:ext>
            </p:extLst>
          </p:nvPr>
        </p:nvGraphicFramePr>
        <p:xfrm>
          <a:off x="4268429" y="4413738"/>
          <a:ext cx="1605445" cy="1210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40" name="グラフ 39">
            <a:extLst>
              <a:ext uri="{FF2B5EF4-FFF2-40B4-BE49-F238E27FC236}">
                <a16:creationId xmlns:a16="http://schemas.microsoft.com/office/drawing/2014/main" id="{064EA0AA-C22F-49AE-9CEA-E0356656FF6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0262701"/>
              </p:ext>
            </p:extLst>
          </p:nvPr>
        </p:nvGraphicFramePr>
        <p:xfrm>
          <a:off x="5853060" y="771839"/>
          <a:ext cx="1605445" cy="12109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41" name="グラフ 40">
            <a:extLst>
              <a:ext uri="{FF2B5EF4-FFF2-40B4-BE49-F238E27FC236}">
                <a16:creationId xmlns:a16="http://schemas.microsoft.com/office/drawing/2014/main" id="{F44D814E-1B36-4F4C-896D-050F941198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5138969"/>
              </p:ext>
            </p:extLst>
          </p:nvPr>
        </p:nvGraphicFramePr>
        <p:xfrm>
          <a:off x="5839817" y="1993601"/>
          <a:ext cx="1605446" cy="1210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42" name="グラフ 41">
            <a:extLst>
              <a:ext uri="{FF2B5EF4-FFF2-40B4-BE49-F238E27FC236}">
                <a16:creationId xmlns:a16="http://schemas.microsoft.com/office/drawing/2014/main" id="{08DE84B1-09F9-44BE-AFED-D8B84AEA35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27899941"/>
              </p:ext>
            </p:extLst>
          </p:nvPr>
        </p:nvGraphicFramePr>
        <p:xfrm>
          <a:off x="5884401" y="3227505"/>
          <a:ext cx="1605445" cy="12081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43" name="グラフ 42">
            <a:extLst>
              <a:ext uri="{FF2B5EF4-FFF2-40B4-BE49-F238E27FC236}">
                <a16:creationId xmlns:a16="http://schemas.microsoft.com/office/drawing/2014/main" id="{098280B6-CF08-4590-8775-7050A320641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453128"/>
              </p:ext>
            </p:extLst>
          </p:nvPr>
        </p:nvGraphicFramePr>
        <p:xfrm>
          <a:off x="5894372" y="4445471"/>
          <a:ext cx="1605446" cy="1210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44" name="グラフ 43">
            <a:extLst>
              <a:ext uri="{FF2B5EF4-FFF2-40B4-BE49-F238E27FC236}">
                <a16:creationId xmlns:a16="http://schemas.microsoft.com/office/drawing/2014/main" id="{835EE864-141E-4AA5-997F-45BF4B12A9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6614042"/>
              </p:ext>
            </p:extLst>
          </p:nvPr>
        </p:nvGraphicFramePr>
        <p:xfrm>
          <a:off x="7508787" y="777832"/>
          <a:ext cx="1605447" cy="1210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aphicFrame>
        <p:nvGraphicFramePr>
          <p:cNvPr id="46" name="グラフ 45">
            <a:extLst>
              <a:ext uri="{FF2B5EF4-FFF2-40B4-BE49-F238E27FC236}">
                <a16:creationId xmlns:a16="http://schemas.microsoft.com/office/drawing/2014/main" id="{9F987B25-799C-48E5-900E-F7EF58B5E46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1401328"/>
              </p:ext>
            </p:extLst>
          </p:nvPr>
        </p:nvGraphicFramePr>
        <p:xfrm>
          <a:off x="7490219" y="3229827"/>
          <a:ext cx="1620145" cy="12164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aphicFrame>
        <p:nvGraphicFramePr>
          <p:cNvPr id="47" name="グラフ 46">
            <a:extLst>
              <a:ext uri="{FF2B5EF4-FFF2-40B4-BE49-F238E27FC236}">
                <a16:creationId xmlns:a16="http://schemas.microsoft.com/office/drawing/2014/main" id="{9D4EB86F-164B-4135-A230-59F3E074F67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1270545"/>
              </p:ext>
            </p:extLst>
          </p:nvPr>
        </p:nvGraphicFramePr>
        <p:xfrm>
          <a:off x="7458505" y="4450791"/>
          <a:ext cx="1620146" cy="1210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183674AD-C712-4537-AC33-0F276CBA7671}"/>
              </a:ext>
            </a:extLst>
          </p:cNvPr>
          <p:cNvSpPr txBox="1"/>
          <p:nvPr/>
        </p:nvSpPr>
        <p:spPr>
          <a:xfrm>
            <a:off x="72566" y="2484951"/>
            <a:ext cx="8997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PGE</a:t>
            </a:r>
            <a:r>
              <a:rPr kumimoji="1" lang="en-US" altLang="ja-JP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0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7141F538-6366-428F-889F-852B285C5170}"/>
              </a:ext>
            </a:extLst>
          </p:cNvPr>
          <p:cNvSpPr txBox="1"/>
          <p:nvPr/>
        </p:nvSpPr>
        <p:spPr>
          <a:xfrm>
            <a:off x="74109" y="3553589"/>
            <a:ext cx="89976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IFN-γ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timulation: Con A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4002E3E0-C19F-4E1A-B12B-9379560EC1AB}"/>
              </a:ext>
            </a:extLst>
          </p:cNvPr>
          <p:cNvSpPr txBox="1"/>
          <p:nvPr/>
        </p:nvSpPr>
        <p:spPr>
          <a:xfrm>
            <a:off x="77195" y="4773952"/>
            <a:ext cx="89976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IFN-γ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timulation: BLV antigen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20FE2F89-C457-463A-832F-F0816CC83C66}"/>
              </a:ext>
            </a:extLst>
          </p:cNvPr>
          <p:cNvSpPr txBox="1"/>
          <p:nvPr/>
        </p:nvSpPr>
        <p:spPr>
          <a:xfrm>
            <a:off x="75639" y="1272026"/>
            <a:ext cx="8997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Estradiol</a:t>
            </a:r>
          </a:p>
        </p:txBody>
      </p:sp>
      <p:graphicFrame>
        <p:nvGraphicFramePr>
          <p:cNvPr id="53" name="グラフ 52">
            <a:extLst>
              <a:ext uri="{FF2B5EF4-FFF2-40B4-BE49-F238E27FC236}">
                <a16:creationId xmlns:a16="http://schemas.microsoft.com/office/drawing/2014/main" id="{E833D5E4-9383-4B5C-9543-3FAD1A76F9A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4401300"/>
              </p:ext>
            </p:extLst>
          </p:nvPr>
        </p:nvGraphicFramePr>
        <p:xfrm>
          <a:off x="7515859" y="2013218"/>
          <a:ext cx="1603558" cy="1189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sp>
        <p:nvSpPr>
          <p:cNvPr id="45" name="TextBox 7">
            <a:extLst>
              <a:ext uri="{FF2B5EF4-FFF2-40B4-BE49-F238E27FC236}">
                <a16:creationId xmlns:a16="http://schemas.microsoft.com/office/drawing/2014/main" id="{F90FD266-558E-4C60-9920-DE0345D95744}"/>
              </a:ext>
            </a:extLst>
          </p:cNvPr>
          <p:cNvSpPr txBox="1"/>
          <p:nvPr/>
        </p:nvSpPr>
        <p:spPr>
          <a:xfrm>
            <a:off x="143065" y="103003"/>
            <a:ext cx="2578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ry Figure 2</a:t>
            </a:r>
            <a:endParaRPr lang="en-US" b="1" dirty="0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76DFEB0A-F1EA-4493-985D-7352B3728C51}"/>
              </a:ext>
            </a:extLst>
          </p:cNvPr>
          <p:cNvSpPr txBox="1"/>
          <p:nvPr/>
        </p:nvSpPr>
        <p:spPr>
          <a:xfrm>
            <a:off x="297004" y="5735832"/>
            <a:ext cx="8549992" cy="9852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050" b="1" dirty="0"/>
              <a:t>Supplementary Figure </a:t>
            </a:r>
            <a:r>
              <a:rPr lang="en-US" altLang="ja-JP" sz="105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05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Functional analysis of estradiol using BLV-infected cattle (raw data). </a:t>
            </a:r>
            <a:endParaRPr lang="ja-JP" altLang="ja-JP" sz="1050" b="1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–d) Estradiol administration was performed using BLV-infected cattle (animals #6–#10). (a) Serum estradiol concentrations were measured by ELISA. (b) Serum PGE</a:t>
            </a:r>
            <a:r>
              <a:rPr lang="en-US" altLang="ja-JP" sz="1050" kern="1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concentrations were measured by ELISA. (c and d) Whole-blood culture or PBMC culture was performed to evaluate IFN-γ production in response to Con A or gp51 peptide mix, respectively.</a:t>
            </a:r>
            <a:endParaRPr lang="ja-JP" altLang="ja-JP" sz="18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92147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per format">
      <a:majorFont>
        <a:latin typeface="Times New Roman"/>
        <a:ea typeface="ＭＳ 明朝"/>
        <a:cs typeface=""/>
      </a:majorFont>
      <a:minorFont>
        <a:latin typeface="Times New Roman"/>
        <a:ea typeface="ＭＳ 明朝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</TotalTime>
  <Words>290</Words>
  <Application>Microsoft Office PowerPoint</Application>
  <PresentationFormat>On-screen Show (4:3)</PresentationFormat>
  <Paragraphs>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orting information 1</dc:title>
  <dc:creator>大和 佐治木</dc:creator>
  <cp:lastModifiedBy>Saranya Siva</cp:lastModifiedBy>
  <cp:revision>15</cp:revision>
  <dcterms:created xsi:type="dcterms:W3CDTF">2020-02-18T07:37:16Z</dcterms:created>
  <dcterms:modified xsi:type="dcterms:W3CDTF">2022-02-15T03:41:08Z</dcterms:modified>
</cp:coreProperties>
</file>